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84" r:id="rId2"/>
    <p:sldId id="286" r:id="rId3"/>
    <p:sldId id="287" r:id="rId4"/>
    <p:sldId id="279" r:id="rId5"/>
    <p:sldId id="278" r:id="rId6"/>
    <p:sldId id="285" r:id="rId7"/>
  </p:sldIdLst>
  <p:sldSz cx="6300788" cy="9906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ken Schmudde" initials="IS" lastIdx="1" clrIdx="0">
    <p:extLst>
      <p:ext uri="{19B8F6BF-5375-455C-9EA6-DF929625EA0E}">
        <p15:presenceInfo xmlns:p15="http://schemas.microsoft.com/office/powerpoint/2012/main" userId="25087d22efca2c0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CC00CC"/>
    <a:srgbClr val="00FF00"/>
    <a:srgbClr val="0000CC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62" autoAdjust="0"/>
    <p:restoredTop sz="94660"/>
  </p:normalViewPr>
  <p:slideViewPr>
    <p:cSldViewPr snapToGrid="0">
      <p:cViewPr varScale="1">
        <p:scale>
          <a:sx n="49" d="100"/>
          <a:sy n="49" d="100"/>
        </p:scale>
        <p:origin x="178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Relationship Id="rId4" Type="http://schemas.openxmlformats.org/officeDocument/2006/relationships/image" Target="../media/image1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70F56A-CE3A-6347-A285-92FA99DF77E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241425"/>
            <a:ext cx="2130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46AD3C-D61A-8C45-880F-46D95C1FB22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9798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1621191"/>
            <a:ext cx="5355670" cy="3448756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5202944"/>
            <a:ext cx="4725591" cy="2391656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8917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3598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527403"/>
            <a:ext cx="1358607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527403"/>
            <a:ext cx="3997062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7094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8270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2469624"/>
            <a:ext cx="5434430" cy="4120620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6629226"/>
            <a:ext cx="5434430" cy="2166937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016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2637014"/>
            <a:ext cx="2677835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2637014"/>
            <a:ext cx="2677835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4047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27405"/>
            <a:ext cx="5434430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2428347"/>
            <a:ext cx="2665528" cy="1190095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3618442"/>
            <a:ext cx="2665528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2428347"/>
            <a:ext cx="2678656" cy="1190095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3618442"/>
            <a:ext cx="2678656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0577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919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993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660400"/>
            <a:ext cx="2032168" cy="2311400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1426283"/>
            <a:ext cx="3189774" cy="7039681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971800"/>
            <a:ext cx="2032168" cy="5505627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6996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660400"/>
            <a:ext cx="2032168" cy="2311400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1426283"/>
            <a:ext cx="3189774" cy="7039681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971800"/>
            <a:ext cx="2032168" cy="5505627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116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527405"/>
            <a:ext cx="543443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2637014"/>
            <a:ext cx="543443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9181397"/>
            <a:ext cx="1417677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C2258-77B7-4B6E-80D8-E8961A9D2D72}" type="datetimeFigureOut">
              <a:rPr lang="de-DE" smtClean="0"/>
              <a:t>28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9181397"/>
            <a:ext cx="2126516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9181397"/>
            <a:ext cx="1417677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DCB43-2730-417E-A0BC-5C8C726DFFD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4875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13.emf"/><Relationship Id="rId4" Type="http://schemas.openxmlformats.org/officeDocument/2006/relationships/image" Target="../media/image10.emf"/><Relationship Id="rId9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8" name="Grafik 24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7781" y="2138786"/>
            <a:ext cx="1612044" cy="1792800"/>
          </a:xfrm>
          <a:prstGeom prst="rect">
            <a:avLst/>
          </a:prstGeom>
        </p:spPr>
      </p:pic>
      <p:pic>
        <p:nvPicPr>
          <p:cNvPr id="245" name="Grafik 2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33323" y="74415"/>
            <a:ext cx="1612044" cy="1792800"/>
          </a:xfrm>
          <a:prstGeom prst="rect">
            <a:avLst/>
          </a:prstGeom>
        </p:spPr>
      </p:pic>
      <p:pic>
        <p:nvPicPr>
          <p:cNvPr id="246" name="Grafik 2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8316" y="71074"/>
            <a:ext cx="1612044" cy="1792800"/>
          </a:xfrm>
          <a:prstGeom prst="rect">
            <a:avLst/>
          </a:prstGeom>
        </p:spPr>
      </p:pic>
      <p:pic>
        <p:nvPicPr>
          <p:cNvPr id="244" name="Grafik 24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5632" y="75963"/>
            <a:ext cx="1610652" cy="1791251"/>
          </a:xfrm>
          <a:prstGeom prst="rect">
            <a:avLst/>
          </a:prstGeom>
        </p:spPr>
      </p:pic>
      <p:sp>
        <p:nvSpPr>
          <p:cNvPr id="49" name="Textfeld 48"/>
          <p:cNvSpPr txBox="1"/>
          <p:nvPr/>
        </p:nvSpPr>
        <p:spPr>
          <a:xfrm>
            <a:off x="2245166" y="1022063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feld 103"/>
          <p:cNvSpPr txBox="1"/>
          <p:nvPr/>
        </p:nvSpPr>
        <p:spPr>
          <a:xfrm>
            <a:off x="2272367" y="2082777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FSC-A</a:t>
            </a:r>
            <a:endParaRPr lang="de-DE" sz="800" b="1" dirty="0"/>
          </a:p>
        </p:txBody>
      </p:sp>
      <p:sp>
        <p:nvSpPr>
          <p:cNvPr id="105" name="Textfeld 104"/>
          <p:cNvSpPr txBox="1"/>
          <p:nvPr/>
        </p:nvSpPr>
        <p:spPr>
          <a:xfrm rot="16200000">
            <a:off x="2006616" y="1747276"/>
            <a:ext cx="69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SSC-A</a:t>
            </a:r>
            <a:endParaRPr lang="de-DE" sz="800" b="1" dirty="0"/>
          </a:p>
        </p:txBody>
      </p:sp>
      <p:cxnSp>
        <p:nvCxnSpPr>
          <p:cNvPr id="106" name="Gerade Verbindung mit Pfeil 105"/>
          <p:cNvCxnSpPr/>
          <p:nvPr/>
        </p:nvCxnSpPr>
        <p:spPr>
          <a:xfrm flipH="1">
            <a:off x="2431191" y="2082777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 Verbindung mit Pfeil 106"/>
          <p:cNvCxnSpPr/>
          <p:nvPr/>
        </p:nvCxnSpPr>
        <p:spPr>
          <a:xfrm>
            <a:off x="2431191" y="1650729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 Verbindung mit Pfeil 107"/>
          <p:cNvCxnSpPr/>
          <p:nvPr/>
        </p:nvCxnSpPr>
        <p:spPr>
          <a:xfrm flipV="1">
            <a:off x="5574907" y="1412900"/>
            <a:ext cx="7988" cy="942924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feld 114"/>
          <p:cNvSpPr txBox="1"/>
          <p:nvPr/>
        </p:nvSpPr>
        <p:spPr>
          <a:xfrm>
            <a:off x="2245166" y="76569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2245166" y="509309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2245166" y="252938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2223132" y="1534816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2245166" y="126989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K</a:t>
            </a:r>
          </a:p>
        </p:txBody>
      </p:sp>
      <p:sp>
        <p:nvSpPr>
          <p:cNvPr id="120" name="Textfeld 119"/>
          <p:cNvSpPr txBox="1"/>
          <p:nvPr/>
        </p:nvSpPr>
        <p:spPr>
          <a:xfrm>
            <a:off x="3062529" y="165327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583831" y="165327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2628467" y="165327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5" name="Textfeld 124"/>
          <p:cNvSpPr txBox="1"/>
          <p:nvPr/>
        </p:nvSpPr>
        <p:spPr>
          <a:xfrm>
            <a:off x="4381610" y="509312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4381610" y="1252798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0" name="Textfeld 129"/>
          <p:cNvSpPr txBox="1"/>
          <p:nvPr/>
        </p:nvSpPr>
        <p:spPr>
          <a:xfrm>
            <a:off x="4381610" y="893878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baseline="30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/>
          <p:cNvSpPr txBox="1"/>
          <p:nvPr/>
        </p:nvSpPr>
        <p:spPr>
          <a:xfrm>
            <a:off x="5198973" y="165327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/>
          <p:cNvSpPr txBox="1"/>
          <p:nvPr/>
        </p:nvSpPr>
        <p:spPr>
          <a:xfrm>
            <a:off x="5720275" y="165327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132"/>
          <p:cNvSpPr txBox="1"/>
          <p:nvPr/>
        </p:nvSpPr>
        <p:spPr>
          <a:xfrm>
            <a:off x="4786945" y="165327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4" name="Textfeld 133"/>
          <p:cNvSpPr txBox="1"/>
          <p:nvPr/>
        </p:nvSpPr>
        <p:spPr>
          <a:xfrm>
            <a:off x="91617" y="1022063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91617" y="76569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feld 135"/>
          <p:cNvSpPr txBox="1"/>
          <p:nvPr/>
        </p:nvSpPr>
        <p:spPr>
          <a:xfrm>
            <a:off x="91617" y="509309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feld 136"/>
          <p:cNvSpPr txBox="1"/>
          <p:nvPr/>
        </p:nvSpPr>
        <p:spPr>
          <a:xfrm>
            <a:off x="91617" y="252938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/>
          <p:cNvSpPr txBox="1"/>
          <p:nvPr/>
        </p:nvSpPr>
        <p:spPr>
          <a:xfrm>
            <a:off x="91617" y="1534816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9" name="Textfeld 138"/>
          <p:cNvSpPr txBox="1"/>
          <p:nvPr/>
        </p:nvSpPr>
        <p:spPr>
          <a:xfrm>
            <a:off x="91617" y="126989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K</a:t>
            </a:r>
          </a:p>
        </p:txBody>
      </p:sp>
      <p:sp>
        <p:nvSpPr>
          <p:cNvPr id="140" name="Textfeld 139"/>
          <p:cNvSpPr txBox="1"/>
          <p:nvPr/>
        </p:nvSpPr>
        <p:spPr>
          <a:xfrm>
            <a:off x="908980" y="165327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feld 140"/>
          <p:cNvSpPr txBox="1"/>
          <p:nvPr/>
        </p:nvSpPr>
        <p:spPr>
          <a:xfrm>
            <a:off x="1430282" y="1653279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feld 141"/>
          <p:cNvSpPr txBox="1"/>
          <p:nvPr/>
        </p:nvSpPr>
        <p:spPr>
          <a:xfrm>
            <a:off x="496952" y="165327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3" name="Textfeld 142"/>
          <p:cNvSpPr txBox="1"/>
          <p:nvPr/>
        </p:nvSpPr>
        <p:spPr>
          <a:xfrm>
            <a:off x="5536002" y="1886030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Living </a:t>
            </a:r>
            <a:br>
              <a:rPr lang="de-DE" sz="800" b="1" dirty="0" smtClean="0"/>
            </a:br>
            <a:r>
              <a:rPr lang="de-DE" sz="800" b="1" dirty="0" err="1" smtClean="0"/>
              <a:t>cells</a:t>
            </a:r>
            <a:endParaRPr lang="de-DE" sz="800" b="1" dirty="0"/>
          </a:p>
        </p:txBody>
      </p:sp>
      <p:sp>
        <p:nvSpPr>
          <p:cNvPr id="144" name="Textfeld 143"/>
          <p:cNvSpPr txBox="1"/>
          <p:nvPr/>
        </p:nvSpPr>
        <p:spPr>
          <a:xfrm>
            <a:off x="4412405" y="2082777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FSC-A</a:t>
            </a:r>
            <a:endParaRPr lang="de-DE" sz="800" b="1" dirty="0"/>
          </a:p>
        </p:txBody>
      </p:sp>
      <p:sp>
        <p:nvSpPr>
          <p:cNvPr id="145" name="Textfeld 144"/>
          <p:cNvSpPr txBox="1"/>
          <p:nvPr/>
        </p:nvSpPr>
        <p:spPr>
          <a:xfrm rot="16200000">
            <a:off x="4067911" y="1707659"/>
            <a:ext cx="7758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err="1" smtClean="0"/>
              <a:t>Viablilty</a:t>
            </a:r>
            <a:r>
              <a:rPr lang="de-DE" sz="800" b="1" dirty="0" smtClean="0"/>
              <a:t> </a:t>
            </a:r>
            <a:r>
              <a:rPr lang="de-DE" sz="800" b="1" dirty="0" err="1" smtClean="0"/>
              <a:t>Dye</a:t>
            </a:r>
            <a:endParaRPr lang="de-DE" sz="800" b="1" dirty="0"/>
          </a:p>
        </p:txBody>
      </p:sp>
      <p:cxnSp>
        <p:nvCxnSpPr>
          <p:cNvPr id="146" name="Gerade Verbindung mit Pfeil 145"/>
          <p:cNvCxnSpPr/>
          <p:nvPr/>
        </p:nvCxnSpPr>
        <p:spPr>
          <a:xfrm flipH="1">
            <a:off x="4571229" y="2082777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Gerade Verbindung mit Pfeil 146"/>
          <p:cNvCxnSpPr/>
          <p:nvPr/>
        </p:nvCxnSpPr>
        <p:spPr>
          <a:xfrm>
            <a:off x="4571229" y="1650729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Gerade Verbindung mit Pfeil 147"/>
          <p:cNvCxnSpPr/>
          <p:nvPr/>
        </p:nvCxnSpPr>
        <p:spPr>
          <a:xfrm flipH="1" flipV="1">
            <a:off x="1430282" y="1021315"/>
            <a:ext cx="962244" cy="8068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feld 148"/>
          <p:cNvSpPr txBox="1"/>
          <p:nvPr/>
        </p:nvSpPr>
        <p:spPr>
          <a:xfrm>
            <a:off x="1857002" y="81783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err="1" smtClean="0"/>
              <a:t>Singlets</a:t>
            </a:r>
            <a:endParaRPr lang="de-DE" sz="800" b="1" dirty="0"/>
          </a:p>
        </p:txBody>
      </p:sp>
      <p:sp>
        <p:nvSpPr>
          <p:cNvPr id="150" name="Textfeld 149"/>
          <p:cNvSpPr txBox="1"/>
          <p:nvPr/>
        </p:nvSpPr>
        <p:spPr>
          <a:xfrm>
            <a:off x="115212" y="2082777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FSC-A</a:t>
            </a:r>
            <a:endParaRPr lang="de-DE" sz="800" b="1" dirty="0"/>
          </a:p>
        </p:txBody>
      </p:sp>
      <p:sp>
        <p:nvSpPr>
          <p:cNvPr id="151" name="Textfeld 150"/>
          <p:cNvSpPr txBox="1"/>
          <p:nvPr/>
        </p:nvSpPr>
        <p:spPr>
          <a:xfrm rot="16200000">
            <a:off x="-189665" y="1747276"/>
            <a:ext cx="69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FSC-H</a:t>
            </a:r>
            <a:endParaRPr lang="de-DE" sz="800" b="1" dirty="0"/>
          </a:p>
        </p:txBody>
      </p:sp>
      <p:cxnSp>
        <p:nvCxnSpPr>
          <p:cNvPr id="152" name="Gerade Verbindung mit Pfeil 151"/>
          <p:cNvCxnSpPr/>
          <p:nvPr/>
        </p:nvCxnSpPr>
        <p:spPr>
          <a:xfrm flipH="1">
            <a:off x="274036" y="2082777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rade Verbindung mit Pfeil 152"/>
          <p:cNvCxnSpPr/>
          <p:nvPr/>
        </p:nvCxnSpPr>
        <p:spPr>
          <a:xfrm>
            <a:off x="274036" y="1650729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47" name="Grafik 24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69304" y="2144183"/>
            <a:ext cx="1608357" cy="1788699"/>
          </a:xfrm>
          <a:prstGeom prst="rect">
            <a:avLst/>
          </a:prstGeom>
        </p:spPr>
      </p:pic>
      <p:pic>
        <p:nvPicPr>
          <p:cNvPr id="249" name="Grafik 24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1506" y="2133368"/>
            <a:ext cx="1612044" cy="1792800"/>
          </a:xfrm>
          <a:prstGeom prst="rect">
            <a:avLst/>
          </a:prstGeom>
        </p:spPr>
      </p:pic>
      <p:sp>
        <p:nvSpPr>
          <p:cNvPr id="272" name="Textfeld 271"/>
          <p:cNvSpPr txBox="1"/>
          <p:nvPr/>
        </p:nvSpPr>
        <p:spPr>
          <a:xfrm>
            <a:off x="4384112" y="3081388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feld 272"/>
          <p:cNvSpPr txBox="1"/>
          <p:nvPr/>
        </p:nvSpPr>
        <p:spPr>
          <a:xfrm>
            <a:off x="4384112" y="2825019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feld 273"/>
          <p:cNvSpPr txBox="1"/>
          <p:nvPr/>
        </p:nvSpPr>
        <p:spPr>
          <a:xfrm>
            <a:off x="4384112" y="256863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feld 274"/>
          <p:cNvSpPr txBox="1"/>
          <p:nvPr/>
        </p:nvSpPr>
        <p:spPr>
          <a:xfrm>
            <a:off x="4384112" y="2312263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K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feld 275"/>
          <p:cNvSpPr txBox="1"/>
          <p:nvPr/>
        </p:nvSpPr>
        <p:spPr>
          <a:xfrm>
            <a:off x="4384112" y="3594141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77" name="Textfeld 276"/>
          <p:cNvSpPr txBox="1"/>
          <p:nvPr/>
        </p:nvSpPr>
        <p:spPr>
          <a:xfrm>
            <a:off x="4384112" y="3329219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K</a:t>
            </a:r>
          </a:p>
        </p:txBody>
      </p:sp>
      <p:sp>
        <p:nvSpPr>
          <p:cNvPr id="278" name="Textfeld 277"/>
          <p:cNvSpPr txBox="1"/>
          <p:nvPr/>
        </p:nvSpPr>
        <p:spPr>
          <a:xfrm>
            <a:off x="5304173" y="371260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feld 278"/>
          <p:cNvSpPr txBox="1"/>
          <p:nvPr/>
        </p:nvSpPr>
        <p:spPr>
          <a:xfrm>
            <a:off x="5954428" y="371260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feld 279"/>
          <p:cNvSpPr txBox="1"/>
          <p:nvPr/>
        </p:nvSpPr>
        <p:spPr>
          <a:xfrm>
            <a:off x="5035630" y="37126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81" name="Textfeld 280"/>
          <p:cNvSpPr txBox="1"/>
          <p:nvPr/>
        </p:nvSpPr>
        <p:spPr>
          <a:xfrm>
            <a:off x="4407707" y="4142102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CD90.2</a:t>
            </a:r>
            <a:endParaRPr lang="de-DE" sz="800" b="1" dirty="0"/>
          </a:p>
        </p:txBody>
      </p:sp>
      <p:sp>
        <p:nvSpPr>
          <p:cNvPr id="282" name="Textfeld 281"/>
          <p:cNvSpPr txBox="1"/>
          <p:nvPr/>
        </p:nvSpPr>
        <p:spPr>
          <a:xfrm rot="16200000">
            <a:off x="4102830" y="3806601"/>
            <a:ext cx="69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SSC-A</a:t>
            </a:r>
            <a:endParaRPr lang="de-DE" sz="800" b="1" dirty="0"/>
          </a:p>
        </p:txBody>
      </p:sp>
      <p:cxnSp>
        <p:nvCxnSpPr>
          <p:cNvPr id="283" name="Gerade Verbindung mit Pfeil 282"/>
          <p:cNvCxnSpPr/>
          <p:nvPr/>
        </p:nvCxnSpPr>
        <p:spPr>
          <a:xfrm flipH="1">
            <a:off x="4566531" y="4142102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Gerade Verbindung mit Pfeil 283"/>
          <p:cNvCxnSpPr/>
          <p:nvPr/>
        </p:nvCxnSpPr>
        <p:spPr>
          <a:xfrm>
            <a:off x="4566531" y="3710054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7" name="Gerade Verbindung mit Pfeil 286"/>
          <p:cNvCxnSpPr/>
          <p:nvPr/>
        </p:nvCxnSpPr>
        <p:spPr>
          <a:xfrm flipH="1">
            <a:off x="4146988" y="3062497"/>
            <a:ext cx="1478705" cy="115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8" name="Textfeld 287"/>
          <p:cNvSpPr txBox="1"/>
          <p:nvPr/>
        </p:nvSpPr>
        <p:spPr>
          <a:xfrm>
            <a:off x="4078921" y="2878009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err="1" smtClean="0"/>
              <a:t>Lympho-cytes</a:t>
            </a:r>
            <a:endParaRPr lang="de-DE" sz="800" b="1" dirty="0"/>
          </a:p>
        </p:txBody>
      </p:sp>
      <p:sp>
        <p:nvSpPr>
          <p:cNvPr id="290" name="Textfeld 289"/>
          <p:cNvSpPr txBox="1"/>
          <p:nvPr/>
        </p:nvSpPr>
        <p:spPr>
          <a:xfrm>
            <a:off x="2247479" y="3012853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feld 290"/>
          <p:cNvSpPr txBox="1"/>
          <p:nvPr/>
        </p:nvSpPr>
        <p:spPr>
          <a:xfrm>
            <a:off x="2247479" y="2686130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feld 291"/>
          <p:cNvSpPr txBox="1"/>
          <p:nvPr/>
        </p:nvSpPr>
        <p:spPr>
          <a:xfrm>
            <a:off x="2247479" y="237114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feld 292"/>
          <p:cNvSpPr txBox="1"/>
          <p:nvPr/>
        </p:nvSpPr>
        <p:spPr>
          <a:xfrm>
            <a:off x="2247479" y="3395116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95" name="Textfeld 294"/>
          <p:cNvSpPr txBox="1"/>
          <p:nvPr/>
        </p:nvSpPr>
        <p:spPr>
          <a:xfrm>
            <a:off x="3179263" y="37128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feld 295"/>
          <p:cNvSpPr txBox="1"/>
          <p:nvPr/>
        </p:nvSpPr>
        <p:spPr>
          <a:xfrm>
            <a:off x="3817795" y="37128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Textfeld 296"/>
          <p:cNvSpPr txBox="1"/>
          <p:nvPr/>
        </p:nvSpPr>
        <p:spPr>
          <a:xfrm>
            <a:off x="2898997" y="371287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98" name="Textfeld 297"/>
          <p:cNvSpPr txBox="1"/>
          <p:nvPr/>
        </p:nvSpPr>
        <p:spPr>
          <a:xfrm>
            <a:off x="2271074" y="4142368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IL-17A</a:t>
            </a:r>
            <a:endParaRPr lang="de-DE" sz="800" b="1" dirty="0"/>
          </a:p>
        </p:txBody>
      </p:sp>
      <p:sp>
        <p:nvSpPr>
          <p:cNvPr id="299" name="Textfeld 298"/>
          <p:cNvSpPr txBox="1"/>
          <p:nvPr/>
        </p:nvSpPr>
        <p:spPr>
          <a:xfrm rot="16200000">
            <a:off x="1966197" y="3806867"/>
            <a:ext cx="69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CD90.2</a:t>
            </a:r>
            <a:endParaRPr lang="de-DE" sz="800" b="1" dirty="0"/>
          </a:p>
        </p:txBody>
      </p:sp>
      <p:cxnSp>
        <p:nvCxnSpPr>
          <p:cNvPr id="300" name="Gerade Verbindung mit Pfeil 299"/>
          <p:cNvCxnSpPr/>
          <p:nvPr/>
        </p:nvCxnSpPr>
        <p:spPr>
          <a:xfrm flipH="1">
            <a:off x="2429898" y="4142368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Gerade Verbindung mit Pfeil 300"/>
          <p:cNvCxnSpPr/>
          <p:nvPr/>
        </p:nvCxnSpPr>
        <p:spPr>
          <a:xfrm>
            <a:off x="2429898" y="3710320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Textfeld 301"/>
          <p:cNvSpPr txBox="1"/>
          <p:nvPr/>
        </p:nvSpPr>
        <p:spPr>
          <a:xfrm>
            <a:off x="5649630" y="371260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Textfeld 302"/>
          <p:cNvSpPr txBox="1"/>
          <p:nvPr/>
        </p:nvSpPr>
        <p:spPr>
          <a:xfrm>
            <a:off x="3524720" y="37128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feld 303"/>
          <p:cNvSpPr txBox="1"/>
          <p:nvPr/>
        </p:nvSpPr>
        <p:spPr>
          <a:xfrm>
            <a:off x="434119" y="3485617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ILCs</a:t>
            </a:r>
            <a:endParaRPr lang="de-DE" sz="800" b="1" dirty="0"/>
          </a:p>
        </p:txBody>
      </p:sp>
      <p:sp>
        <p:nvSpPr>
          <p:cNvPr id="305" name="Textfeld 304"/>
          <p:cNvSpPr txBox="1"/>
          <p:nvPr/>
        </p:nvSpPr>
        <p:spPr>
          <a:xfrm>
            <a:off x="1142898" y="3241183"/>
            <a:ext cx="8707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800" b="1" dirty="0" smtClean="0"/>
              <a:t>Non-</a:t>
            </a:r>
            <a:r>
              <a:rPr lang="de-DE" sz="800" b="1" dirty="0" err="1" smtClean="0"/>
              <a:t>conventional</a:t>
            </a:r>
            <a:r>
              <a:rPr lang="de-DE" sz="800" b="1" dirty="0" smtClean="0"/>
              <a:t> </a:t>
            </a:r>
            <a:br>
              <a:rPr lang="de-DE" sz="800" b="1" dirty="0" smtClean="0"/>
            </a:br>
            <a:r>
              <a:rPr lang="de-DE" sz="800" b="1" dirty="0" smtClean="0"/>
              <a:t>T </a:t>
            </a:r>
            <a:r>
              <a:rPr lang="de-DE" sz="800" b="1" dirty="0" err="1" smtClean="0"/>
              <a:t>cells</a:t>
            </a:r>
            <a:endParaRPr lang="de-DE" sz="800" b="1" dirty="0"/>
          </a:p>
        </p:txBody>
      </p:sp>
      <p:sp>
        <p:nvSpPr>
          <p:cNvPr id="306" name="Textfeld 305"/>
          <p:cNvSpPr txBox="1"/>
          <p:nvPr/>
        </p:nvSpPr>
        <p:spPr>
          <a:xfrm>
            <a:off x="1395405" y="2371925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800" b="1" dirty="0"/>
              <a:t>α</a:t>
            </a:r>
            <a:r>
              <a:rPr lang="el-GR" sz="800" b="1" dirty="0" smtClean="0"/>
              <a:t>β</a:t>
            </a:r>
            <a:r>
              <a:rPr lang="de-DE" sz="800" b="1" dirty="0" smtClean="0"/>
              <a:t> T </a:t>
            </a:r>
            <a:r>
              <a:rPr lang="de-DE" sz="800" b="1" dirty="0" err="1" smtClean="0"/>
              <a:t>cells</a:t>
            </a:r>
            <a:endParaRPr lang="de-DE" sz="800" b="1" dirty="0"/>
          </a:p>
        </p:txBody>
      </p:sp>
      <p:cxnSp>
        <p:nvCxnSpPr>
          <p:cNvPr id="307" name="Gerade Verbindung mit Pfeil 306"/>
          <p:cNvCxnSpPr/>
          <p:nvPr/>
        </p:nvCxnSpPr>
        <p:spPr>
          <a:xfrm flipH="1">
            <a:off x="3994589" y="1013524"/>
            <a:ext cx="634932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8" name="Textfeld 307"/>
          <p:cNvSpPr txBox="1"/>
          <p:nvPr/>
        </p:nvSpPr>
        <p:spPr>
          <a:xfrm>
            <a:off x="4078921" y="81783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Cells</a:t>
            </a:r>
            <a:endParaRPr lang="de-DE" sz="800" b="1" dirty="0"/>
          </a:p>
        </p:txBody>
      </p:sp>
      <p:sp>
        <p:nvSpPr>
          <p:cNvPr id="310" name="Textfeld 309"/>
          <p:cNvSpPr txBox="1"/>
          <p:nvPr/>
        </p:nvSpPr>
        <p:spPr>
          <a:xfrm>
            <a:off x="89384" y="3013613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1" name="Textfeld 310"/>
          <p:cNvSpPr txBox="1"/>
          <p:nvPr/>
        </p:nvSpPr>
        <p:spPr>
          <a:xfrm>
            <a:off x="89384" y="2686890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2" name="Textfeld 311"/>
          <p:cNvSpPr txBox="1"/>
          <p:nvPr/>
        </p:nvSpPr>
        <p:spPr>
          <a:xfrm>
            <a:off x="89384" y="2371904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Textfeld 312"/>
          <p:cNvSpPr txBox="1"/>
          <p:nvPr/>
        </p:nvSpPr>
        <p:spPr>
          <a:xfrm>
            <a:off x="89384" y="3395876"/>
            <a:ext cx="5291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4" name="Textfeld 313"/>
          <p:cNvSpPr txBox="1"/>
          <p:nvPr/>
        </p:nvSpPr>
        <p:spPr>
          <a:xfrm>
            <a:off x="1021168" y="371363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Textfeld 314"/>
          <p:cNvSpPr txBox="1"/>
          <p:nvPr/>
        </p:nvSpPr>
        <p:spPr>
          <a:xfrm>
            <a:off x="1659700" y="371363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feld 315"/>
          <p:cNvSpPr txBox="1"/>
          <p:nvPr/>
        </p:nvSpPr>
        <p:spPr>
          <a:xfrm>
            <a:off x="740902" y="371363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7" name="Textfeld 316"/>
          <p:cNvSpPr txBox="1"/>
          <p:nvPr/>
        </p:nvSpPr>
        <p:spPr>
          <a:xfrm>
            <a:off x="112979" y="4143128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CD3</a:t>
            </a:r>
            <a:endParaRPr lang="de-DE" sz="800" b="1" dirty="0"/>
          </a:p>
        </p:txBody>
      </p:sp>
      <p:sp>
        <p:nvSpPr>
          <p:cNvPr id="318" name="Textfeld 317"/>
          <p:cNvSpPr txBox="1"/>
          <p:nvPr/>
        </p:nvSpPr>
        <p:spPr>
          <a:xfrm rot="16200000">
            <a:off x="-191898" y="3807627"/>
            <a:ext cx="6965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TCR</a:t>
            </a:r>
            <a:r>
              <a:rPr lang="el-GR" sz="800" b="1" dirty="0" smtClean="0"/>
              <a:t>β</a:t>
            </a:r>
            <a:endParaRPr lang="de-DE" sz="800" b="1" dirty="0"/>
          </a:p>
        </p:txBody>
      </p:sp>
      <p:cxnSp>
        <p:nvCxnSpPr>
          <p:cNvPr id="319" name="Gerade Verbindung mit Pfeil 318"/>
          <p:cNvCxnSpPr/>
          <p:nvPr/>
        </p:nvCxnSpPr>
        <p:spPr>
          <a:xfrm flipH="1">
            <a:off x="271803" y="4143128"/>
            <a:ext cx="432048" cy="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Gerade Verbindung mit Pfeil 319"/>
          <p:cNvCxnSpPr/>
          <p:nvPr/>
        </p:nvCxnSpPr>
        <p:spPr>
          <a:xfrm>
            <a:off x="271803" y="3711080"/>
            <a:ext cx="0" cy="432048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sm" len="sm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1" name="Textfeld 320"/>
          <p:cNvSpPr txBox="1"/>
          <p:nvPr/>
        </p:nvSpPr>
        <p:spPr>
          <a:xfrm>
            <a:off x="1366625" y="371363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8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2" name="Gerade Verbindung mit Pfeil 321"/>
          <p:cNvCxnSpPr/>
          <p:nvPr/>
        </p:nvCxnSpPr>
        <p:spPr>
          <a:xfrm flipH="1">
            <a:off x="1984430" y="3058797"/>
            <a:ext cx="1478705" cy="1154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Textfeld 322"/>
          <p:cNvSpPr txBox="1"/>
          <p:nvPr/>
        </p:nvSpPr>
        <p:spPr>
          <a:xfrm>
            <a:off x="1916363" y="2874309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 smtClean="0"/>
              <a:t>IL17A</a:t>
            </a:r>
            <a:r>
              <a:rPr lang="de-DE" sz="800" b="1" baseline="30000" dirty="0" smtClean="0"/>
              <a:t>+</a:t>
            </a:r>
            <a:endParaRPr lang="de-DE" sz="800" b="1" baseline="30000" dirty="0"/>
          </a:p>
        </p:txBody>
      </p:sp>
      <p:sp>
        <p:nvSpPr>
          <p:cNvPr id="2" name="Textfeld 1"/>
          <p:cNvSpPr txBox="1"/>
          <p:nvPr/>
        </p:nvSpPr>
        <p:spPr>
          <a:xfrm>
            <a:off x="271803" y="4403649"/>
            <a:ext cx="575780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1: Gating strategy for the analysis 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7A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57BL/6 mice were treated with vancomycin, ampicillin and gentamycin (all at 1.0 mg/mL)(Abx) from prenatal day 15 until birth. Mice treated with sucralose served as controls (ctrl.). At 6-8 weeks, offspring C57BL/6 mice were immunized i.p. with 10 µg/100 µL of HDM. Seven days later mice received an additional i.p. injection of HDM. After 14 and 21 days mice were treated with 100 µg/40 µL HDM i.t. Mice treated with PBS served as non-asthmatic controls. 72 h after the last treatment single lung cell suspensions were restimulated with PMA (50 ng/mL) and ionomycin (0.5 mg/mL). Follow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ltiple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dead cell exclusion CD90.2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identified. IL-17A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90.2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identified. Differential expression of CD3 and TCRβ allowed identification of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Rβ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αβ T cells,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Rβ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-conventional 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nd 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Rβ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C3s. Dot plots are representativ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a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st 5 independent experiments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652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71803" y="2801433"/>
            <a:ext cx="575780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Analysi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57BL/6 mice were treated with vancomycin, ampicillin and gentamycin (all at 1.0 mg/mL)(Abx) from prenatal day 15 until birth. Mice treated with sucralose served as controls (ctrl.). At 6-8 weeks, offspring C57BL/6 mice were immunized i.p. with 10 µg/100 µL of HDM. Seven days later mice received an additional i.p. injection of HDM. After 14 and 21 days mice were treated with 100 µg/40 µL HDM i.t. Mice treated with PBS served as non-asthmatic controls. 72 h after the last treatment single lung cell suspensions were restimulated with PMA (50 ng/mL) and ionomycin (0.5 mg/mL). After intracellular staining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90.2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mphocytes were analyzed regard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13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duction by flow cytometry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atter plot with mean ± SEM; n =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-18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. Each dot represents o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use. Differenc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groups were tested by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allis-Test and Dunn’s Pos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 for significance; </a:t>
            </a:r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0.00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6093898"/>
              </p:ext>
            </p:extLst>
          </p:nvPr>
        </p:nvGraphicFramePr>
        <p:xfrm>
          <a:off x="1408008" y="0"/>
          <a:ext cx="3495759" cy="28595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Prism 5" r:id="rId3" imgW="3314880" imgH="2711160" progId="Prism5.Document">
                  <p:embed/>
                </p:oleObj>
              </mc:Choice>
              <mc:Fallback>
                <p:oleObj name="Prism 5" r:id="rId3" imgW="3314880" imgH="2711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08008" y="0"/>
                        <a:ext cx="3495759" cy="28595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274298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2668933"/>
              </p:ext>
            </p:extLst>
          </p:nvPr>
        </p:nvGraphicFramePr>
        <p:xfrm>
          <a:off x="2846530" y="0"/>
          <a:ext cx="3176269" cy="192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2" name="Prism 5" r:id="rId3" imgW="4695480" imgH="2853000" progId="Prism5.Document">
                  <p:embed/>
                </p:oleObj>
              </mc:Choice>
              <mc:Fallback>
                <p:oleObj name="Prism 5" r:id="rId3" imgW="4695480" imgH="2853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46530" y="0"/>
                        <a:ext cx="3176269" cy="192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9148262"/>
              </p:ext>
            </p:extLst>
          </p:nvPr>
        </p:nvGraphicFramePr>
        <p:xfrm>
          <a:off x="106983" y="0"/>
          <a:ext cx="2411095" cy="183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3" name="Prism 5" r:id="rId5" imgW="3561480" imgH="2711160" progId="Prism5.Document">
                  <p:embed/>
                </p:oleObj>
              </mc:Choice>
              <mc:Fallback>
                <p:oleObj name="Prism 5" r:id="rId5" imgW="3561480" imgH="2711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6983" y="0"/>
                        <a:ext cx="2411095" cy="183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43"/>
          <p:cNvSpPr txBox="1">
            <a:spLocks noChangeArrowheads="1"/>
          </p:cNvSpPr>
          <p:nvPr/>
        </p:nvSpPr>
        <p:spPr bwMode="auto">
          <a:xfrm>
            <a:off x="-6233" y="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43"/>
          <p:cNvSpPr txBox="1">
            <a:spLocks noChangeArrowheads="1"/>
          </p:cNvSpPr>
          <p:nvPr/>
        </p:nvSpPr>
        <p:spPr bwMode="auto">
          <a:xfrm>
            <a:off x="2708188" y="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71803" y="1963233"/>
            <a:ext cx="5757805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" pitchFamily="18" charset="0"/>
                <a:cs typeface="Times New Roman" panose="02020603050405020304" pitchFamily="18" charset="0"/>
              </a:rPr>
              <a:t>Suppl. Figure 3: </a:t>
            </a:r>
            <a:r>
              <a:rPr lang="en-US" sz="1200" b="1" dirty="0">
                <a:latin typeface="Times" pitchFamily="18" charset="0"/>
              </a:rPr>
              <a:t>Prenatal antibiotic exposure increases the n</a:t>
            </a:r>
            <a:r>
              <a:rPr lang="en-US" sz="1200" b="1" dirty="0" smtClean="0">
                <a:latin typeface="Times" pitchFamily="18" charset="0"/>
              </a:rPr>
              <a:t>umber of </a:t>
            </a:r>
            <a:r>
              <a:rPr lang="en-US" sz="1200" b="1" dirty="0">
                <a:latin typeface="Times" pitchFamily="18" charset="0"/>
              </a:rPr>
              <a:t>IL-17A</a:t>
            </a:r>
            <a:r>
              <a:rPr lang="en-US" sz="1200" b="1" baseline="30000" dirty="0">
                <a:latin typeface="Times" pitchFamily="18" charset="0"/>
              </a:rPr>
              <a:t>+</a:t>
            </a:r>
            <a:r>
              <a:rPr lang="en-US" sz="1200" b="1" dirty="0">
                <a:latin typeface="Times" pitchFamily="18" charset="0"/>
              </a:rPr>
              <a:t> pulmonary </a:t>
            </a:r>
            <a:r>
              <a:rPr lang="en-US" sz="1200" b="1" dirty="0" smtClean="0">
                <a:latin typeface="Times" pitchFamily="18" charset="0"/>
              </a:rPr>
              <a:t>cells. </a:t>
            </a:r>
            <a:r>
              <a:rPr lang="en-US" sz="1200" dirty="0" smtClean="0">
                <a:latin typeface="Times" pitchFamily="18" charset="0"/>
              </a:rPr>
              <a:t>C57BL/6 </a:t>
            </a:r>
            <a:r>
              <a:rPr lang="en-US" sz="1200" dirty="0">
                <a:latin typeface="Times" pitchFamily="18" charset="0"/>
              </a:rPr>
              <a:t>mice were treated with vancomycin, ampicillin and gentamycin (all at 1.0 mg/mL)(Abx) from prenatal day 15 until birth. Mice treated with sucralose served as controls (ctrl.). At 6-8 weeks, offspring C57BL/6 mice were immunized i.p. with 10 µg/100 µL of HDM. Seven days later mice received an additional i.p. injection of HDM. After 14 and 21 days mice were treated with 100 µg/40 µL HDM i.t. Mice treated with PBS served as non-asthmatic controls </a:t>
            </a:r>
            <a:r>
              <a:rPr lang="en-US" sz="1200" dirty="0" smtClean="0">
                <a:latin typeface="Times" pitchFamily="18" charset="0"/>
              </a:rPr>
              <a:t>(A). </a:t>
            </a:r>
            <a:r>
              <a:rPr lang="en-US" sz="1200" dirty="0">
                <a:latin typeface="Times" pitchFamily="18" charset="0"/>
              </a:rPr>
              <a:t>72 h after the last treatment the asthma phenotype was assessed. </a:t>
            </a:r>
            <a:r>
              <a:rPr lang="en-US" sz="1200" b="1" dirty="0" smtClean="0">
                <a:latin typeface="Times" pitchFamily="18" charset="0"/>
              </a:rPr>
              <a:t>(A) </a:t>
            </a:r>
            <a:r>
              <a:rPr lang="en-US" sz="1200" dirty="0">
                <a:latin typeface="Times" pitchFamily="18" charset="0"/>
              </a:rPr>
              <a:t>Single lung cell suspensions were restimulated with PMA (50 ng/mL) and ionomycin (0.5 mg/mL). After intracellular staining of IL-17A, CD90.2</a:t>
            </a:r>
            <a:r>
              <a:rPr lang="en-US" sz="1200" baseline="30000" dirty="0">
                <a:latin typeface="Times" pitchFamily="18" charset="0"/>
              </a:rPr>
              <a:t>+</a:t>
            </a:r>
            <a:r>
              <a:rPr lang="en-US" sz="1200" dirty="0">
                <a:latin typeface="Times" pitchFamily="18" charset="0"/>
              </a:rPr>
              <a:t> lymphocytes were analyzed regarding IL-17A production by flow cytometry. </a:t>
            </a:r>
            <a:r>
              <a:rPr lang="en-US" sz="1200" b="1" dirty="0" smtClean="0">
                <a:latin typeface="Times" pitchFamily="18" charset="0"/>
              </a:rPr>
              <a:t>(B)</a:t>
            </a:r>
            <a:r>
              <a:rPr lang="en-US" sz="1200" dirty="0" smtClean="0">
                <a:latin typeface="Times" pitchFamily="18" charset="0"/>
              </a:rPr>
              <a:t> </a:t>
            </a:r>
            <a:r>
              <a:rPr lang="en-US" sz="1200" dirty="0">
                <a:latin typeface="Times" pitchFamily="18" charset="0"/>
              </a:rPr>
              <a:t>To further differentiate IL-17A</a:t>
            </a:r>
            <a:r>
              <a:rPr lang="en-US" sz="1200" baseline="30000" dirty="0">
                <a:latin typeface="Times" pitchFamily="18" charset="0"/>
              </a:rPr>
              <a:t>+</a:t>
            </a:r>
            <a:r>
              <a:rPr lang="en-US" sz="1200" dirty="0">
                <a:latin typeface="Times" pitchFamily="18" charset="0"/>
              </a:rPr>
              <a:t> populations, CD3 and TCRβ expression was analyzed to identify CD3</a:t>
            </a:r>
            <a:r>
              <a:rPr lang="en-US" sz="1200" baseline="30000" dirty="0">
                <a:latin typeface="Times" pitchFamily="18" charset="0"/>
              </a:rPr>
              <a:t>+</a:t>
            </a:r>
            <a:r>
              <a:rPr lang="en-US" sz="1200" dirty="0">
                <a:latin typeface="Times" pitchFamily="18" charset="0"/>
              </a:rPr>
              <a:t>TCRβ</a:t>
            </a:r>
            <a:r>
              <a:rPr lang="en-US" sz="1200" baseline="30000" dirty="0">
                <a:latin typeface="Times" pitchFamily="18" charset="0"/>
              </a:rPr>
              <a:t>+</a:t>
            </a:r>
            <a:r>
              <a:rPr lang="en-US" sz="1200" dirty="0">
                <a:latin typeface="Times" pitchFamily="18" charset="0"/>
              </a:rPr>
              <a:t> αβ T cells, CD3</a:t>
            </a:r>
            <a:r>
              <a:rPr lang="en-US" sz="1200" baseline="30000" dirty="0">
                <a:latin typeface="Times" pitchFamily="18" charset="0"/>
              </a:rPr>
              <a:t>+</a:t>
            </a:r>
            <a:r>
              <a:rPr lang="en-US" sz="1200" dirty="0">
                <a:latin typeface="Times" pitchFamily="18" charset="0"/>
              </a:rPr>
              <a:t>TCRβ</a:t>
            </a:r>
            <a:r>
              <a:rPr lang="en-US" sz="1200" baseline="30000" dirty="0">
                <a:latin typeface="Times" pitchFamily="18" charset="0"/>
              </a:rPr>
              <a:t>-</a:t>
            </a:r>
            <a:r>
              <a:rPr lang="en-US" sz="1200" dirty="0">
                <a:latin typeface="Times" pitchFamily="18" charset="0"/>
              </a:rPr>
              <a:t> non-conventional T cells and CD3</a:t>
            </a:r>
            <a:r>
              <a:rPr lang="en-US" sz="1200" baseline="30000" dirty="0">
                <a:latin typeface="Times" pitchFamily="18" charset="0"/>
              </a:rPr>
              <a:t>-</a:t>
            </a:r>
            <a:r>
              <a:rPr lang="en-US" sz="1200" dirty="0">
                <a:latin typeface="Times" pitchFamily="18" charset="0"/>
              </a:rPr>
              <a:t>TCRβ</a:t>
            </a:r>
            <a:r>
              <a:rPr lang="en-US" sz="1200" baseline="30000" dirty="0">
                <a:latin typeface="Times" pitchFamily="18" charset="0"/>
              </a:rPr>
              <a:t>-</a:t>
            </a:r>
            <a:r>
              <a:rPr lang="en-US" sz="1200" dirty="0">
                <a:latin typeface="Times" pitchFamily="18" charset="0"/>
              </a:rPr>
              <a:t> ILCs. </a:t>
            </a:r>
            <a:r>
              <a:rPr lang="en-US" sz="1200" dirty="0" smtClean="0">
                <a:latin typeface="Times" pitchFamily="18" charset="0"/>
              </a:rPr>
              <a:t>Scatter </a:t>
            </a:r>
            <a:r>
              <a:rPr lang="en-US" sz="1200" dirty="0">
                <a:latin typeface="Times" pitchFamily="18" charset="0"/>
              </a:rPr>
              <a:t>plot with mean ± SEM; n = </a:t>
            </a:r>
            <a:r>
              <a:rPr lang="en-US" sz="1200" dirty="0" smtClean="0">
                <a:latin typeface="Times" pitchFamily="18" charset="0"/>
              </a:rPr>
              <a:t>5-20 </a:t>
            </a:r>
            <a:r>
              <a:rPr lang="en-US" sz="1200" dirty="0">
                <a:latin typeface="Times" pitchFamily="18" charset="0"/>
              </a:rPr>
              <a:t>mice. Each dot represents one mouse. Differences between groups were tested by </a:t>
            </a:r>
            <a:r>
              <a:rPr lang="en-US" sz="1200" dirty="0" err="1">
                <a:latin typeface="Times" pitchFamily="18" charset="0"/>
              </a:rPr>
              <a:t>Kruskal</a:t>
            </a:r>
            <a:r>
              <a:rPr lang="en-US" sz="1200" dirty="0">
                <a:latin typeface="Times" pitchFamily="18" charset="0"/>
              </a:rPr>
              <a:t>-Wallis-Test and </a:t>
            </a:r>
            <a:r>
              <a:rPr lang="en-US" sz="1200" dirty="0" err="1">
                <a:latin typeface="Times" pitchFamily="18" charset="0"/>
              </a:rPr>
              <a:t>Dunns’s</a:t>
            </a:r>
            <a:r>
              <a:rPr lang="en-US" sz="1200" dirty="0">
                <a:latin typeface="Times" pitchFamily="18" charset="0"/>
              </a:rPr>
              <a:t> Post Test </a:t>
            </a:r>
            <a:r>
              <a:rPr lang="en-US" sz="1200" dirty="0" smtClean="0">
                <a:latin typeface="Times" pitchFamily="18" charset="0"/>
              </a:rPr>
              <a:t>(</a:t>
            </a:r>
            <a:r>
              <a:rPr lang="en-US" sz="1200" dirty="0">
                <a:latin typeface="Times" pitchFamily="18" charset="0"/>
              </a:rPr>
              <a:t>A)</a:t>
            </a:r>
            <a:r>
              <a:rPr lang="en-US" sz="1200" dirty="0" smtClean="0">
                <a:latin typeface="Times" pitchFamily="18" charset="0"/>
              </a:rPr>
              <a:t> </a:t>
            </a:r>
            <a:r>
              <a:rPr lang="en-US" sz="1200" dirty="0">
                <a:latin typeface="Times" pitchFamily="18" charset="0"/>
              </a:rPr>
              <a:t>and </a:t>
            </a:r>
            <a:r>
              <a:rPr lang="en-US" sz="1200" dirty="0" smtClean="0">
                <a:latin typeface="Times" pitchFamily="18" charset="0"/>
              </a:rPr>
              <a:t>Mann-Whitney-U-Test (B) for significance; </a:t>
            </a:r>
            <a:r>
              <a:rPr lang="en-US" sz="1200" dirty="0">
                <a:latin typeface="Times" pitchFamily="18" charset="0"/>
              </a:rPr>
              <a:t>* p &lt; </a:t>
            </a:r>
            <a:r>
              <a:rPr lang="en-US" sz="1200" dirty="0" smtClean="0">
                <a:latin typeface="Times" pitchFamily="18" charset="0"/>
              </a:rPr>
              <a:t>0.05.</a:t>
            </a:r>
            <a:endParaRPr lang="de-DE" sz="1200" dirty="0">
              <a:latin typeface="Times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05797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3056191"/>
              </p:ext>
            </p:extLst>
          </p:nvPr>
        </p:nvGraphicFramePr>
        <p:xfrm>
          <a:off x="4417200" y="28800"/>
          <a:ext cx="1888694" cy="14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0" name="Prism 5" r:id="rId3" imgW="3488400" imgH="2692800" progId="Prism5.Document">
                  <p:embed/>
                </p:oleObj>
              </mc:Choice>
              <mc:Fallback>
                <p:oleObj name="Prism 5" r:id="rId3" imgW="3488400" imgH="2692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17200" y="28800"/>
                        <a:ext cx="1888694" cy="14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8955938"/>
              </p:ext>
            </p:extLst>
          </p:nvPr>
        </p:nvGraphicFramePr>
        <p:xfrm>
          <a:off x="2941200" y="28800"/>
          <a:ext cx="1646268" cy="14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1" name="Prism 5" r:id="rId5" imgW="3040200" imgH="2692800" progId="Prism5.Document">
                  <p:embed/>
                </p:oleObj>
              </mc:Choice>
              <mc:Fallback>
                <p:oleObj name="Prism 5" r:id="rId5" imgW="3040200" imgH="2692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41200" y="28800"/>
                        <a:ext cx="1646268" cy="14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9033190"/>
              </p:ext>
            </p:extLst>
          </p:nvPr>
        </p:nvGraphicFramePr>
        <p:xfrm>
          <a:off x="1458000" y="28800"/>
          <a:ext cx="1666040" cy="14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2" name="Prism 5" r:id="rId7" imgW="3076920" imgH="2692800" progId="Prism5.Document">
                  <p:embed/>
                </p:oleObj>
              </mc:Choice>
              <mc:Fallback>
                <p:oleObj name="Prism 5" r:id="rId7" imgW="3076920" imgH="2692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58000" y="28800"/>
                        <a:ext cx="1666040" cy="14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1422778"/>
              </p:ext>
            </p:extLst>
          </p:nvPr>
        </p:nvGraphicFramePr>
        <p:xfrm>
          <a:off x="0" y="28800"/>
          <a:ext cx="1646268" cy="14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name="Prism 5" r:id="rId9" imgW="3040200" imgH="2692800" progId="Prism5.Document">
                  <p:embed/>
                </p:oleObj>
              </mc:Choice>
              <mc:Fallback>
                <p:oleObj name="Prism 5" r:id="rId9" imgW="3040200" imgH="26928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0" y="28800"/>
                        <a:ext cx="1646268" cy="14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43"/>
          <p:cNvSpPr txBox="1">
            <a:spLocks noChangeArrowheads="1"/>
          </p:cNvSpPr>
          <p:nvPr/>
        </p:nvSpPr>
        <p:spPr bwMode="auto">
          <a:xfrm>
            <a:off x="-6233" y="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43"/>
          <p:cNvSpPr txBox="1">
            <a:spLocks noChangeArrowheads="1"/>
          </p:cNvSpPr>
          <p:nvPr/>
        </p:nvSpPr>
        <p:spPr bwMode="auto">
          <a:xfrm>
            <a:off x="1465431" y="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271803" y="1524734"/>
            <a:ext cx="575780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natal antibiotic exposu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ams only mildly increases mucus associated gene expression by pulmonary cel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57BL/6 mice were treated with vancomycin, ampicillin and gentamycin (all at 1.0 mg/mL)(Abx) from prenatal day 15 until birth. Mice treated with sucralose served as controls (ctrl.). At 6-8 weeks, offspring C57BL/6 mice were immunized i.p. with 10 µg/100 µL of HDM. Seven days later mice received an additional i.p. injection of HDM. After 14 and 21 days mice were treated with 100 µg/40 µL HDM i.t. Mice treated with PBS served as non-asthmatic controls. 72 h after the las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 RNA expression of a neutrophil marker gen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ucus-related genes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to the expression of the housekeeping gene S14 by pulmonary 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asses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catter plot with mean ± SEM; n ≥ 5 per group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groups were tested by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Wallis-Test and Dunn’s Pos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 for significance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&lt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7540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19" r="1942"/>
          <a:stretch/>
        </p:blipFill>
        <p:spPr>
          <a:xfrm>
            <a:off x="140832" y="19455"/>
            <a:ext cx="6114053" cy="6165987"/>
          </a:xfrm>
          <a:prstGeom prst="rect">
            <a:avLst/>
          </a:prstGeom>
        </p:spPr>
      </p:pic>
      <p:sp>
        <p:nvSpPr>
          <p:cNvPr id="6" name="Textfeld 43"/>
          <p:cNvSpPr txBox="1">
            <a:spLocks noChangeArrowheads="1"/>
          </p:cNvSpPr>
          <p:nvPr/>
        </p:nvSpPr>
        <p:spPr bwMode="auto">
          <a:xfrm rot="16200000">
            <a:off x="-454866" y="946181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/J wt mous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43"/>
          <p:cNvSpPr txBox="1">
            <a:spLocks noChangeArrowheads="1"/>
          </p:cNvSpPr>
          <p:nvPr/>
        </p:nvSpPr>
        <p:spPr bwMode="auto">
          <a:xfrm rot="16200000">
            <a:off x="-611228" y="2912923"/>
            <a:ext cx="148323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/J RORC-GFP mouse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43"/>
          <p:cNvSpPr txBox="1">
            <a:spLocks noChangeArrowheads="1"/>
          </p:cNvSpPr>
          <p:nvPr/>
        </p:nvSpPr>
        <p:spPr bwMode="auto">
          <a:xfrm rot="16200000">
            <a:off x="-454865" y="4877178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63"/>
          <p:cNvSpPr txBox="1"/>
          <p:nvPr/>
        </p:nvSpPr>
        <p:spPr>
          <a:xfrm>
            <a:off x="3743928" y="3676292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0" name="Textfeld 63"/>
          <p:cNvSpPr txBox="1"/>
          <p:nvPr/>
        </p:nvSpPr>
        <p:spPr>
          <a:xfrm>
            <a:off x="5738112" y="3676292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1" name="Textfeld 63"/>
          <p:cNvSpPr txBox="1"/>
          <p:nvPr/>
        </p:nvSpPr>
        <p:spPr>
          <a:xfrm>
            <a:off x="1759479" y="3676292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2" name="Textfeld 63"/>
          <p:cNvSpPr txBox="1"/>
          <p:nvPr/>
        </p:nvSpPr>
        <p:spPr>
          <a:xfrm>
            <a:off x="3743928" y="5680203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3" name="Textfeld 63"/>
          <p:cNvSpPr txBox="1"/>
          <p:nvPr/>
        </p:nvSpPr>
        <p:spPr>
          <a:xfrm>
            <a:off x="5738112" y="5680203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4" name="Textfeld 63"/>
          <p:cNvSpPr txBox="1"/>
          <p:nvPr/>
        </p:nvSpPr>
        <p:spPr>
          <a:xfrm>
            <a:off x="1759479" y="5680203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5" name="Textfeld 63"/>
          <p:cNvSpPr txBox="1"/>
          <p:nvPr/>
        </p:nvSpPr>
        <p:spPr>
          <a:xfrm>
            <a:off x="3743928" y="1682113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6" name="Textfeld 63"/>
          <p:cNvSpPr txBox="1"/>
          <p:nvPr/>
        </p:nvSpPr>
        <p:spPr>
          <a:xfrm>
            <a:off x="5738112" y="1682113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7" name="Textfeld 63"/>
          <p:cNvSpPr txBox="1"/>
          <p:nvPr/>
        </p:nvSpPr>
        <p:spPr>
          <a:xfrm>
            <a:off x="1759479" y="1682113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20 </a:t>
            </a:r>
            <a:r>
              <a:rPr lang="en-US" sz="800" kern="1200" dirty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sp>
        <p:nvSpPr>
          <p:cNvPr id="18" name="Textfeld 43"/>
          <p:cNvSpPr txBox="1">
            <a:spLocks noChangeArrowheads="1"/>
          </p:cNvSpPr>
          <p:nvPr/>
        </p:nvSpPr>
        <p:spPr bwMode="auto">
          <a:xfrm>
            <a:off x="-6233" y="2055833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43"/>
          <p:cNvSpPr txBox="1">
            <a:spLocks noChangeArrowheads="1"/>
          </p:cNvSpPr>
          <p:nvPr/>
        </p:nvSpPr>
        <p:spPr bwMode="auto">
          <a:xfrm>
            <a:off x="-6233" y="329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43"/>
          <p:cNvSpPr txBox="1">
            <a:spLocks noChangeArrowheads="1"/>
          </p:cNvSpPr>
          <p:nvPr/>
        </p:nvSpPr>
        <p:spPr bwMode="auto">
          <a:xfrm>
            <a:off x="-6233" y="4040285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43"/>
          <p:cNvSpPr txBox="1">
            <a:spLocks noChangeArrowheads="1"/>
          </p:cNvSpPr>
          <p:nvPr/>
        </p:nvSpPr>
        <p:spPr bwMode="auto">
          <a:xfrm>
            <a:off x="268258" y="2041969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800" b="1" dirty="0">
                <a:solidFill>
                  <a:schemeClr val="bg1"/>
                </a:solidFill>
                <a:latin typeface="Cambria Math" panose="02040503050406030204" pitchFamily="18" charset="0"/>
                <a:ea typeface="Cambria Math" panose="02040503050406030204" pitchFamily="18" charset="0"/>
                <a:cs typeface="Arial" panose="020B0604020202020204" pitchFamily="34" charset="0"/>
              </a:rPr>
              <a:t>γ</a:t>
            </a:r>
            <a:r>
              <a: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43"/>
          <p:cNvSpPr txBox="1">
            <a:spLocks noChangeArrowheads="1"/>
          </p:cNvSpPr>
          <p:nvPr/>
        </p:nvSpPr>
        <p:spPr bwMode="auto">
          <a:xfrm>
            <a:off x="4246400" y="2042967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43"/>
          <p:cNvSpPr txBox="1">
            <a:spLocks noChangeArrowheads="1"/>
          </p:cNvSpPr>
          <p:nvPr/>
        </p:nvSpPr>
        <p:spPr bwMode="auto">
          <a:xfrm>
            <a:off x="2261498" y="2042967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43"/>
          <p:cNvSpPr txBox="1">
            <a:spLocks noChangeArrowheads="1"/>
          </p:cNvSpPr>
          <p:nvPr/>
        </p:nvSpPr>
        <p:spPr bwMode="auto">
          <a:xfrm>
            <a:off x="268258" y="4036154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800" b="1" dirty="0">
                <a:solidFill>
                  <a:schemeClr val="bg1"/>
                </a:solidFill>
                <a:latin typeface="Cambria Math" panose="02040503050406030204" pitchFamily="18" charset="0"/>
                <a:ea typeface="Cambria Math" panose="02040503050406030204" pitchFamily="18" charset="0"/>
                <a:cs typeface="Arial" panose="020B0604020202020204" pitchFamily="34" charset="0"/>
              </a:rPr>
              <a:t>γ</a:t>
            </a:r>
            <a:r>
              <a: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43"/>
          <p:cNvSpPr txBox="1">
            <a:spLocks noChangeArrowheads="1"/>
          </p:cNvSpPr>
          <p:nvPr/>
        </p:nvSpPr>
        <p:spPr bwMode="auto">
          <a:xfrm>
            <a:off x="4246400" y="4037152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43"/>
          <p:cNvSpPr txBox="1">
            <a:spLocks noChangeArrowheads="1"/>
          </p:cNvSpPr>
          <p:nvPr/>
        </p:nvSpPr>
        <p:spPr bwMode="auto">
          <a:xfrm>
            <a:off x="2261498" y="4037152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43"/>
          <p:cNvSpPr txBox="1">
            <a:spLocks noChangeArrowheads="1"/>
          </p:cNvSpPr>
          <p:nvPr/>
        </p:nvSpPr>
        <p:spPr bwMode="auto">
          <a:xfrm>
            <a:off x="268258" y="47792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</a:t>
            </a:r>
            <a:r>
              <a:rPr lang="el-GR" sz="800" b="1" dirty="0">
                <a:solidFill>
                  <a:schemeClr val="bg1"/>
                </a:solidFill>
                <a:latin typeface="Cambria Math" panose="02040503050406030204" pitchFamily="18" charset="0"/>
                <a:ea typeface="Cambria Math" panose="02040503050406030204" pitchFamily="18" charset="0"/>
                <a:cs typeface="Arial" panose="020B0604020202020204" pitchFamily="34" charset="0"/>
              </a:rPr>
              <a:t>γ</a:t>
            </a:r>
            <a:r>
              <a:rPr lang="de-DE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43"/>
          <p:cNvSpPr txBox="1">
            <a:spLocks noChangeArrowheads="1"/>
          </p:cNvSpPr>
          <p:nvPr/>
        </p:nvSpPr>
        <p:spPr bwMode="auto">
          <a:xfrm>
            <a:off x="4246400" y="48790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43"/>
          <p:cNvSpPr txBox="1">
            <a:spLocks noChangeArrowheads="1"/>
          </p:cNvSpPr>
          <p:nvPr/>
        </p:nvSpPr>
        <p:spPr bwMode="auto">
          <a:xfrm>
            <a:off x="2261498" y="48790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Gerader Verbinder 3"/>
          <p:cNvCxnSpPr/>
          <p:nvPr/>
        </p:nvCxnSpPr>
        <p:spPr>
          <a:xfrm>
            <a:off x="5863659" y="5892544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r Verbinder 29"/>
          <p:cNvCxnSpPr/>
          <p:nvPr/>
        </p:nvCxnSpPr>
        <p:spPr>
          <a:xfrm>
            <a:off x="1889191" y="5892544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/>
          <p:cNvCxnSpPr/>
          <p:nvPr/>
        </p:nvCxnSpPr>
        <p:spPr>
          <a:xfrm>
            <a:off x="3880947" y="5892544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r Verbinder 31"/>
          <p:cNvCxnSpPr/>
          <p:nvPr/>
        </p:nvCxnSpPr>
        <p:spPr>
          <a:xfrm>
            <a:off x="5863659" y="1890903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r Verbinder 32"/>
          <p:cNvCxnSpPr/>
          <p:nvPr/>
        </p:nvCxnSpPr>
        <p:spPr>
          <a:xfrm>
            <a:off x="1889191" y="1890903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/>
          <p:cNvCxnSpPr/>
          <p:nvPr/>
        </p:nvCxnSpPr>
        <p:spPr>
          <a:xfrm>
            <a:off x="3880947" y="1890903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/>
          <p:cNvCxnSpPr/>
          <p:nvPr/>
        </p:nvCxnSpPr>
        <p:spPr>
          <a:xfrm>
            <a:off x="5863659" y="3891736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/>
          <p:cNvCxnSpPr/>
          <p:nvPr/>
        </p:nvCxnSpPr>
        <p:spPr>
          <a:xfrm>
            <a:off x="1889191" y="3891736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/>
          <p:cNvCxnSpPr/>
          <p:nvPr/>
        </p:nvCxnSpPr>
        <p:spPr>
          <a:xfrm>
            <a:off x="3880947" y="3891736"/>
            <a:ext cx="252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271803" y="6141825"/>
            <a:ext cx="575780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5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Rγt IHC staining is suitable in intestinal section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8 µm intestina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yosectio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A/J wt mic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A/J RORC-GFP reporter mic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incubated with anti-RORγt (red) and anti-GFP (green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sections were incubated with secondary antibodies alone. Stained slices were evaluated with laser scanning confocal microscopy generating Z-Stacks. Data are representative of two independent experiments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9508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66" t="7462" r="33787" b="10777"/>
          <a:stretch/>
        </p:blipFill>
        <p:spPr>
          <a:xfrm>
            <a:off x="276225" y="58306"/>
            <a:ext cx="2844000" cy="2844000"/>
          </a:xfrm>
          <a:prstGeom prst="rect">
            <a:avLst/>
          </a:prstGeom>
        </p:spPr>
      </p:pic>
      <p:pic>
        <p:nvPicPr>
          <p:cNvPr id="3" name="Grafik 2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10" t="8913" r="32993" b="8773"/>
          <a:stretch/>
        </p:blipFill>
        <p:spPr>
          <a:xfrm>
            <a:off x="3383256" y="58306"/>
            <a:ext cx="2844000" cy="2844000"/>
          </a:xfrm>
          <a:prstGeom prst="rect">
            <a:avLst/>
          </a:prstGeom>
        </p:spPr>
      </p:pic>
      <p:sp>
        <p:nvSpPr>
          <p:cNvPr id="6" name="Textfeld 63"/>
          <p:cNvSpPr txBox="1"/>
          <p:nvPr/>
        </p:nvSpPr>
        <p:spPr>
          <a:xfrm>
            <a:off x="2591403" y="2544984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50 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cxnSp>
        <p:nvCxnSpPr>
          <p:cNvPr id="7" name="Gerader Verbinder 6"/>
          <p:cNvCxnSpPr/>
          <p:nvPr/>
        </p:nvCxnSpPr>
        <p:spPr>
          <a:xfrm>
            <a:off x="2566497" y="2760428"/>
            <a:ext cx="414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feld 63"/>
          <p:cNvSpPr txBox="1"/>
          <p:nvPr/>
        </p:nvSpPr>
        <p:spPr>
          <a:xfrm>
            <a:off x="5688911" y="2554508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 fontAlgn="base">
              <a:spcAft>
                <a:spcPts val="0"/>
              </a:spcAft>
            </a:pPr>
            <a:r>
              <a:rPr lang="en-US" sz="800" kern="1200" dirty="0" smtClean="0">
                <a:solidFill>
                  <a:srgbClr val="FFFFFF"/>
                </a:solidFill>
                <a:effectLst/>
                <a:latin typeface="Arial" panose="020B0604020202020204" pitchFamily="34" charset="0"/>
                <a:ea typeface="MS Mincho"/>
                <a:cs typeface="Arial" panose="020B0604020202020204" pitchFamily="34" charset="0"/>
              </a:rPr>
              <a:t>50 µm</a:t>
            </a:r>
            <a:endParaRPr lang="de-DE" sz="800" dirty="0">
              <a:effectLst/>
              <a:latin typeface="Arial" panose="020B0604020202020204" pitchFamily="34" charset="0"/>
              <a:ea typeface="MS Mincho"/>
              <a:cs typeface="Arial" panose="020B0604020202020204" pitchFamily="34" charset="0"/>
            </a:endParaRPr>
          </a:p>
        </p:txBody>
      </p:sp>
      <p:cxnSp>
        <p:nvCxnSpPr>
          <p:cNvPr id="9" name="Gerader Verbinder 8"/>
          <p:cNvCxnSpPr/>
          <p:nvPr/>
        </p:nvCxnSpPr>
        <p:spPr>
          <a:xfrm>
            <a:off x="5664005" y="2769952"/>
            <a:ext cx="41400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feld 43"/>
          <p:cNvSpPr txBox="1">
            <a:spLocks noChangeArrowheads="1"/>
          </p:cNvSpPr>
          <p:nvPr/>
        </p:nvSpPr>
        <p:spPr bwMode="auto">
          <a:xfrm>
            <a:off x="3373408" y="47792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800" b="1" dirty="0" smtClean="0">
                <a:solidFill>
                  <a:schemeClr val="bg1"/>
                </a:solidFill>
                <a:latin typeface="Cambria Math" panose="02040503050406030204" pitchFamily="18" charset="0"/>
                <a:ea typeface="Cambria Math" panose="02040503050406030204" pitchFamily="18" charset="0"/>
                <a:cs typeface="Arial" panose="020B0604020202020204" pitchFamily="34" charset="0"/>
              </a:rPr>
              <a:t>β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43"/>
          <p:cNvSpPr txBox="1">
            <a:spLocks noChangeArrowheads="1"/>
          </p:cNvSpPr>
          <p:nvPr/>
        </p:nvSpPr>
        <p:spPr bwMode="auto">
          <a:xfrm>
            <a:off x="268258" y="47792"/>
            <a:ext cx="117051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GB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R</a:t>
            </a:r>
            <a:r>
              <a:rPr lang="el-GR" sz="800" b="1" dirty="0" smtClean="0">
                <a:solidFill>
                  <a:schemeClr val="bg1"/>
                </a:solidFill>
                <a:latin typeface="Cambria Math" panose="02040503050406030204" pitchFamily="18" charset="0"/>
                <a:ea typeface="Cambria Math" panose="02040503050406030204" pitchFamily="18" charset="0"/>
                <a:cs typeface="Arial" panose="020B0604020202020204" pitchFamily="34" charset="0"/>
              </a:rPr>
              <a:t>β</a:t>
            </a:r>
            <a:endParaRPr lang="en-GB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ihandform 13"/>
          <p:cNvSpPr/>
          <p:nvPr/>
        </p:nvSpPr>
        <p:spPr>
          <a:xfrm>
            <a:off x="295275" y="66675"/>
            <a:ext cx="1638300" cy="1162050"/>
          </a:xfrm>
          <a:custGeom>
            <a:avLst/>
            <a:gdLst>
              <a:gd name="connsiteX0" fmla="*/ 0 w 1638300"/>
              <a:gd name="connsiteY0" fmla="*/ 1162050 h 1162050"/>
              <a:gd name="connsiteX1" fmla="*/ 66675 w 1638300"/>
              <a:gd name="connsiteY1" fmla="*/ 1152525 h 1162050"/>
              <a:gd name="connsiteX2" fmla="*/ 95250 w 1638300"/>
              <a:gd name="connsiteY2" fmla="*/ 1143000 h 1162050"/>
              <a:gd name="connsiteX3" fmla="*/ 133350 w 1638300"/>
              <a:gd name="connsiteY3" fmla="*/ 1085850 h 1162050"/>
              <a:gd name="connsiteX4" fmla="*/ 161925 w 1638300"/>
              <a:gd name="connsiteY4" fmla="*/ 1057275 h 1162050"/>
              <a:gd name="connsiteX5" fmla="*/ 257175 w 1638300"/>
              <a:gd name="connsiteY5" fmla="*/ 990600 h 1162050"/>
              <a:gd name="connsiteX6" fmla="*/ 285750 w 1638300"/>
              <a:gd name="connsiteY6" fmla="*/ 971550 h 1162050"/>
              <a:gd name="connsiteX7" fmla="*/ 314325 w 1638300"/>
              <a:gd name="connsiteY7" fmla="*/ 952500 h 1162050"/>
              <a:gd name="connsiteX8" fmla="*/ 342900 w 1638300"/>
              <a:gd name="connsiteY8" fmla="*/ 942975 h 1162050"/>
              <a:gd name="connsiteX9" fmla="*/ 381000 w 1638300"/>
              <a:gd name="connsiteY9" fmla="*/ 914400 h 1162050"/>
              <a:gd name="connsiteX10" fmla="*/ 409575 w 1638300"/>
              <a:gd name="connsiteY10" fmla="*/ 885825 h 1162050"/>
              <a:gd name="connsiteX11" fmla="*/ 466725 w 1638300"/>
              <a:gd name="connsiteY11" fmla="*/ 847725 h 1162050"/>
              <a:gd name="connsiteX12" fmla="*/ 495300 w 1638300"/>
              <a:gd name="connsiteY12" fmla="*/ 819150 h 1162050"/>
              <a:gd name="connsiteX13" fmla="*/ 533400 w 1638300"/>
              <a:gd name="connsiteY13" fmla="*/ 800100 h 1162050"/>
              <a:gd name="connsiteX14" fmla="*/ 561975 w 1638300"/>
              <a:gd name="connsiteY14" fmla="*/ 771525 h 1162050"/>
              <a:gd name="connsiteX15" fmla="*/ 600075 w 1638300"/>
              <a:gd name="connsiteY15" fmla="*/ 742950 h 1162050"/>
              <a:gd name="connsiteX16" fmla="*/ 657225 w 1638300"/>
              <a:gd name="connsiteY16" fmla="*/ 695325 h 1162050"/>
              <a:gd name="connsiteX17" fmla="*/ 676275 w 1638300"/>
              <a:gd name="connsiteY17" fmla="*/ 666750 h 1162050"/>
              <a:gd name="connsiteX18" fmla="*/ 733425 w 1638300"/>
              <a:gd name="connsiteY18" fmla="*/ 638175 h 1162050"/>
              <a:gd name="connsiteX19" fmla="*/ 762000 w 1638300"/>
              <a:gd name="connsiteY19" fmla="*/ 619125 h 1162050"/>
              <a:gd name="connsiteX20" fmla="*/ 819150 w 1638300"/>
              <a:gd name="connsiteY20" fmla="*/ 561975 h 1162050"/>
              <a:gd name="connsiteX21" fmla="*/ 866775 w 1638300"/>
              <a:gd name="connsiteY21" fmla="*/ 504825 h 1162050"/>
              <a:gd name="connsiteX22" fmla="*/ 933450 w 1638300"/>
              <a:gd name="connsiteY22" fmla="*/ 466725 h 1162050"/>
              <a:gd name="connsiteX23" fmla="*/ 990600 w 1638300"/>
              <a:gd name="connsiteY23" fmla="*/ 428625 h 1162050"/>
              <a:gd name="connsiteX24" fmla="*/ 1047750 w 1638300"/>
              <a:gd name="connsiteY24" fmla="*/ 390525 h 1162050"/>
              <a:gd name="connsiteX25" fmla="*/ 1114425 w 1638300"/>
              <a:gd name="connsiteY25" fmla="*/ 342900 h 1162050"/>
              <a:gd name="connsiteX26" fmla="*/ 1143000 w 1638300"/>
              <a:gd name="connsiteY26" fmla="*/ 333375 h 1162050"/>
              <a:gd name="connsiteX27" fmla="*/ 1228725 w 1638300"/>
              <a:gd name="connsiteY27" fmla="*/ 276225 h 1162050"/>
              <a:gd name="connsiteX28" fmla="*/ 1257300 w 1638300"/>
              <a:gd name="connsiteY28" fmla="*/ 257175 h 1162050"/>
              <a:gd name="connsiteX29" fmla="*/ 1295400 w 1638300"/>
              <a:gd name="connsiteY29" fmla="*/ 247650 h 1162050"/>
              <a:gd name="connsiteX30" fmla="*/ 1323975 w 1638300"/>
              <a:gd name="connsiteY30" fmla="*/ 228600 h 1162050"/>
              <a:gd name="connsiteX31" fmla="*/ 1352550 w 1638300"/>
              <a:gd name="connsiteY31" fmla="*/ 219075 h 1162050"/>
              <a:gd name="connsiteX32" fmla="*/ 1381125 w 1638300"/>
              <a:gd name="connsiteY32" fmla="*/ 190500 h 1162050"/>
              <a:gd name="connsiteX33" fmla="*/ 1409700 w 1638300"/>
              <a:gd name="connsiteY33" fmla="*/ 171450 h 1162050"/>
              <a:gd name="connsiteX34" fmla="*/ 1438275 w 1638300"/>
              <a:gd name="connsiteY34" fmla="*/ 142875 h 1162050"/>
              <a:gd name="connsiteX35" fmla="*/ 1495425 w 1638300"/>
              <a:gd name="connsiteY35" fmla="*/ 104775 h 1162050"/>
              <a:gd name="connsiteX36" fmla="*/ 1543050 w 1638300"/>
              <a:gd name="connsiteY36" fmla="*/ 66675 h 1162050"/>
              <a:gd name="connsiteX37" fmla="*/ 1600200 w 1638300"/>
              <a:gd name="connsiteY37" fmla="*/ 28575 h 1162050"/>
              <a:gd name="connsiteX38" fmla="*/ 1638300 w 1638300"/>
              <a:gd name="connsiteY38" fmla="*/ 0 h 11620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1638300" h="1162050">
                <a:moveTo>
                  <a:pt x="0" y="1162050"/>
                </a:moveTo>
                <a:cubicBezTo>
                  <a:pt x="22225" y="1158875"/>
                  <a:pt x="44660" y="1156928"/>
                  <a:pt x="66675" y="1152525"/>
                </a:cubicBezTo>
                <a:cubicBezTo>
                  <a:pt x="76520" y="1150556"/>
                  <a:pt x="88150" y="1150100"/>
                  <a:pt x="95250" y="1143000"/>
                </a:cubicBezTo>
                <a:cubicBezTo>
                  <a:pt x="111439" y="1126811"/>
                  <a:pt x="117161" y="1102039"/>
                  <a:pt x="133350" y="1085850"/>
                </a:cubicBezTo>
                <a:cubicBezTo>
                  <a:pt x="142875" y="1076325"/>
                  <a:pt x="151698" y="1066041"/>
                  <a:pt x="161925" y="1057275"/>
                </a:cubicBezTo>
                <a:cubicBezTo>
                  <a:pt x="186607" y="1036119"/>
                  <a:pt x="232584" y="1006994"/>
                  <a:pt x="257175" y="990600"/>
                </a:cubicBezTo>
                <a:lnTo>
                  <a:pt x="285750" y="971550"/>
                </a:lnTo>
                <a:cubicBezTo>
                  <a:pt x="295275" y="965200"/>
                  <a:pt x="303465" y="956120"/>
                  <a:pt x="314325" y="952500"/>
                </a:cubicBezTo>
                <a:lnTo>
                  <a:pt x="342900" y="942975"/>
                </a:lnTo>
                <a:cubicBezTo>
                  <a:pt x="355600" y="933450"/>
                  <a:pt x="368947" y="924731"/>
                  <a:pt x="381000" y="914400"/>
                </a:cubicBezTo>
                <a:cubicBezTo>
                  <a:pt x="391227" y="905634"/>
                  <a:pt x="398942" y="894095"/>
                  <a:pt x="409575" y="885825"/>
                </a:cubicBezTo>
                <a:cubicBezTo>
                  <a:pt x="427647" y="871769"/>
                  <a:pt x="450536" y="863914"/>
                  <a:pt x="466725" y="847725"/>
                </a:cubicBezTo>
                <a:cubicBezTo>
                  <a:pt x="476250" y="838200"/>
                  <a:pt x="484339" y="826980"/>
                  <a:pt x="495300" y="819150"/>
                </a:cubicBezTo>
                <a:cubicBezTo>
                  <a:pt x="506854" y="810897"/>
                  <a:pt x="521846" y="808353"/>
                  <a:pt x="533400" y="800100"/>
                </a:cubicBezTo>
                <a:cubicBezTo>
                  <a:pt x="544361" y="792270"/>
                  <a:pt x="551748" y="780291"/>
                  <a:pt x="561975" y="771525"/>
                </a:cubicBezTo>
                <a:cubicBezTo>
                  <a:pt x="574028" y="761194"/>
                  <a:pt x="588022" y="753281"/>
                  <a:pt x="600075" y="742950"/>
                </a:cubicBezTo>
                <a:cubicBezTo>
                  <a:pt x="664247" y="687945"/>
                  <a:pt x="594070" y="737429"/>
                  <a:pt x="657225" y="695325"/>
                </a:cubicBezTo>
                <a:cubicBezTo>
                  <a:pt x="663575" y="685800"/>
                  <a:pt x="668180" y="674845"/>
                  <a:pt x="676275" y="666750"/>
                </a:cubicBezTo>
                <a:cubicBezTo>
                  <a:pt x="703572" y="639453"/>
                  <a:pt x="702437" y="653669"/>
                  <a:pt x="733425" y="638175"/>
                </a:cubicBezTo>
                <a:cubicBezTo>
                  <a:pt x="743664" y="633055"/>
                  <a:pt x="753444" y="626730"/>
                  <a:pt x="762000" y="619125"/>
                </a:cubicBezTo>
                <a:cubicBezTo>
                  <a:pt x="782136" y="601227"/>
                  <a:pt x="804206" y="584391"/>
                  <a:pt x="819150" y="561975"/>
                </a:cubicBezTo>
                <a:cubicBezTo>
                  <a:pt x="837881" y="533878"/>
                  <a:pt x="839273" y="527744"/>
                  <a:pt x="866775" y="504825"/>
                </a:cubicBezTo>
                <a:cubicBezTo>
                  <a:pt x="895017" y="481290"/>
                  <a:pt x="900178" y="486688"/>
                  <a:pt x="933450" y="466725"/>
                </a:cubicBezTo>
                <a:cubicBezTo>
                  <a:pt x="953083" y="454945"/>
                  <a:pt x="974411" y="444814"/>
                  <a:pt x="990600" y="428625"/>
                </a:cubicBezTo>
                <a:cubicBezTo>
                  <a:pt x="1026275" y="392950"/>
                  <a:pt x="1006396" y="404310"/>
                  <a:pt x="1047750" y="390525"/>
                </a:cubicBezTo>
                <a:cubicBezTo>
                  <a:pt x="1056379" y="384053"/>
                  <a:pt x="1100497" y="349864"/>
                  <a:pt x="1114425" y="342900"/>
                </a:cubicBezTo>
                <a:cubicBezTo>
                  <a:pt x="1123405" y="338410"/>
                  <a:pt x="1134223" y="338251"/>
                  <a:pt x="1143000" y="333375"/>
                </a:cubicBezTo>
                <a:lnTo>
                  <a:pt x="1228725" y="276225"/>
                </a:lnTo>
                <a:cubicBezTo>
                  <a:pt x="1238250" y="269875"/>
                  <a:pt x="1246194" y="259951"/>
                  <a:pt x="1257300" y="257175"/>
                </a:cubicBezTo>
                <a:lnTo>
                  <a:pt x="1295400" y="247650"/>
                </a:lnTo>
                <a:cubicBezTo>
                  <a:pt x="1304925" y="241300"/>
                  <a:pt x="1313736" y="233720"/>
                  <a:pt x="1323975" y="228600"/>
                </a:cubicBezTo>
                <a:cubicBezTo>
                  <a:pt x="1332955" y="224110"/>
                  <a:pt x="1344196" y="224644"/>
                  <a:pt x="1352550" y="219075"/>
                </a:cubicBezTo>
                <a:cubicBezTo>
                  <a:pt x="1363758" y="211603"/>
                  <a:pt x="1370777" y="199124"/>
                  <a:pt x="1381125" y="190500"/>
                </a:cubicBezTo>
                <a:cubicBezTo>
                  <a:pt x="1389919" y="183171"/>
                  <a:pt x="1400906" y="178779"/>
                  <a:pt x="1409700" y="171450"/>
                </a:cubicBezTo>
                <a:cubicBezTo>
                  <a:pt x="1420048" y="162826"/>
                  <a:pt x="1427642" y="151145"/>
                  <a:pt x="1438275" y="142875"/>
                </a:cubicBezTo>
                <a:cubicBezTo>
                  <a:pt x="1456347" y="128819"/>
                  <a:pt x="1495425" y="104775"/>
                  <a:pt x="1495425" y="104775"/>
                </a:cubicBezTo>
                <a:cubicBezTo>
                  <a:pt x="1530624" y="51977"/>
                  <a:pt x="1494336" y="93738"/>
                  <a:pt x="1543050" y="66675"/>
                </a:cubicBezTo>
                <a:cubicBezTo>
                  <a:pt x="1563064" y="55556"/>
                  <a:pt x="1578480" y="35815"/>
                  <a:pt x="1600200" y="28575"/>
                </a:cubicBezTo>
                <a:cubicBezTo>
                  <a:pt x="1635510" y="16805"/>
                  <a:pt x="1624285" y="28030"/>
                  <a:pt x="1638300" y="0"/>
                </a:cubicBezTo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Freihandform 15"/>
          <p:cNvSpPr/>
          <p:nvPr/>
        </p:nvSpPr>
        <p:spPr>
          <a:xfrm>
            <a:off x="2124075" y="2000250"/>
            <a:ext cx="981075" cy="876300"/>
          </a:xfrm>
          <a:custGeom>
            <a:avLst/>
            <a:gdLst>
              <a:gd name="connsiteX0" fmla="*/ 0 w 981075"/>
              <a:gd name="connsiteY0" fmla="*/ 876300 h 876300"/>
              <a:gd name="connsiteX1" fmla="*/ 76200 w 981075"/>
              <a:gd name="connsiteY1" fmla="*/ 828675 h 876300"/>
              <a:gd name="connsiteX2" fmla="*/ 161925 w 981075"/>
              <a:gd name="connsiteY2" fmla="*/ 752475 h 876300"/>
              <a:gd name="connsiteX3" fmla="*/ 228600 w 981075"/>
              <a:gd name="connsiteY3" fmla="*/ 657225 h 876300"/>
              <a:gd name="connsiteX4" fmla="*/ 247650 w 981075"/>
              <a:gd name="connsiteY4" fmla="*/ 628650 h 876300"/>
              <a:gd name="connsiteX5" fmla="*/ 276225 w 981075"/>
              <a:gd name="connsiteY5" fmla="*/ 600075 h 876300"/>
              <a:gd name="connsiteX6" fmla="*/ 323850 w 981075"/>
              <a:gd name="connsiteY6" fmla="*/ 552450 h 876300"/>
              <a:gd name="connsiteX7" fmla="*/ 361950 w 981075"/>
              <a:gd name="connsiteY7" fmla="*/ 514350 h 876300"/>
              <a:gd name="connsiteX8" fmla="*/ 390525 w 981075"/>
              <a:gd name="connsiteY8" fmla="*/ 485775 h 876300"/>
              <a:gd name="connsiteX9" fmla="*/ 428625 w 981075"/>
              <a:gd name="connsiteY9" fmla="*/ 466725 h 876300"/>
              <a:gd name="connsiteX10" fmla="*/ 485775 w 981075"/>
              <a:gd name="connsiteY10" fmla="*/ 428625 h 876300"/>
              <a:gd name="connsiteX11" fmla="*/ 514350 w 981075"/>
              <a:gd name="connsiteY11" fmla="*/ 409575 h 876300"/>
              <a:gd name="connsiteX12" fmla="*/ 571500 w 981075"/>
              <a:gd name="connsiteY12" fmla="*/ 361950 h 876300"/>
              <a:gd name="connsiteX13" fmla="*/ 600075 w 981075"/>
              <a:gd name="connsiteY13" fmla="*/ 333375 h 876300"/>
              <a:gd name="connsiteX14" fmla="*/ 638175 w 981075"/>
              <a:gd name="connsiteY14" fmla="*/ 314325 h 876300"/>
              <a:gd name="connsiteX15" fmla="*/ 695325 w 981075"/>
              <a:gd name="connsiteY15" fmla="*/ 285750 h 876300"/>
              <a:gd name="connsiteX16" fmla="*/ 781050 w 981075"/>
              <a:gd name="connsiteY16" fmla="*/ 219075 h 876300"/>
              <a:gd name="connsiteX17" fmla="*/ 809625 w 981075"/>
              <a:gd name="connsiteY17" fmla="*/ 200025 h 876300"/>
              <a:gd name="connsiteX18" fmla="*/ 838200 w 981075"/>
              <a:gd name="connsiteY18" fmla="*/ 180975 h 876300"/>
              <a:gd name="connsiteX19" fmla="*/ 885825 w 981075"/>
              <a:gd name="connsiteY19" fmla="*/ 123825 h 876300"/>
              <a:gd name="connsiteX20" fmla="*/ 933450 w 981075"/>
              <a:gd name="connsiteY20" fmla="*/ 47625 h 876300"/>
              <a:gd name="connsiteX21" fmla="*/ 981075 w 981075"/>
              <a:gd name="connsiteY21" fmla="*/ 0 h 8763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</a:cxnLst>
            <a:rect l="l" t="t" r="r" b="b"/>
            <a:pathLst>
              <a:path w="981075" h="876300">
                <a:moveTo>
                  <a:pt x="0" y="876300"/>
                </a:moveTo>
                <a:cubicBezTo>
                  <a:pt x="2731" y="874661"/>
                  <a:pt x="66051" y="837696"/>
                  <a:pt x="76200" y="828675"/>
                </a:cubicBezTo>
                <a:cubicBezTo>
                  <a:pt x="174067" y="741682"/>
                  <a:pt x="97072" y="795710"/>
                  <a:pt x="161925" y="752475"/>
                </a:cubicBezTo>
                <a:cubicBezTo>
                  <a:pt x="249513" y="621093"/>
                  <a:pt x="158080" y="755953"/>
                  <a:pt x="228600" y="657225"/>
                </a:cubicBezTo>
                <a:cubicBezTo>
                  <a:pt x="235254" y="647910"/>
                  <a:pt x="240321" y="637444"/>
                  <a:pt x="247650" y="628650"/>
                </a:cubicBezTo>
                <a:cubicBezTo>
                  <a:pt x="256274" y="618302"/>
                  <a:pt x="267601" y="610423"/>
                  <a:pt x="276225" y="600075"/>
                </a:cubicBezTo>
                <a:cubicBezTo>
                  <a:pt x="315912" y="552450"/>
                  <a:pt x="271463" y="587375"/>
                  <a:pt x="323850" y="552450"/>
                </a:cubicBezTo>
                <a:cubicBezTo>
                  <a:pt x="341993" y="498021"/>
                  <a:pt x="318407" y="543379"/>
                  <a:pt x="361950" y="514350"/>
                </a:cubicBezTo>
                <a:cubicBezTo>
                  <a:pt x="373158" y="506878"/>
                  <a:pt x="379564" y="493605"/>
                  <a:pt x="390525" y="485775"/>
                </a:cubicBezTo>
                <a:cubicBezTo>
                  <a:pt x="402079" y="477522"/>
                  <a:pt x="416449" y="474030"/>
                  <a:pt x="428625" y="466725"/>
                </a:cubicBezTo>
                <a:cubicBezTo>
                  <a:pt x="448258" y="454945"/>
                  <a:pt x="466725" y="441325"/>
                  <a:pt x="485775" y="428625"/>
                </a:cubicBezTo>
                <a:cubicBezTo>
                  <a:pt x="495300" y="422275"/>
                  <a:pt x="506255" y="417670"/>
                  <a:pt x="514350" y="409575"/>
                </a:cubicBezTo>
                <a:cubicBezTo>
                  <a:pt x="597832" y="326093"/>
                  <a:pt x="491934" y="428255"/>
                  <a:pt x="571500" y="361950"/>
                </a:cubicBezTo>
                <a:cubicBezTo>
                  <a:pt x="581848" y="353326"/>
                  <a:pt x="589114" y="341205"/>
                  <a:pt x="600075" y="333375"/>
                </a:cubicBezTo>
                <a:cubicBezTo>
                  <a:pt x="611629" y="325122"/>
                  <a:pt x="625847" y="321370"/>
                  <a:pt x="638175" y="314325"/>
                </a:cubicBezTo>
                <a:cubicBezTo>
                  <a:pt x="689876" y="284782"/>
                  <a:pt x="642934" y="303214"/>
                  <a:pt x="695325" y="285750"/>
                </a:cubicBezTo>
                <a:cubicBezTo>
                  <a:pt x="740089" y="240986"/>
                  <a:pt x="712692" y="264647"/>
                  <a:pt x="781050" y="219075"/>
                </a:cubicBezTo>
                <a:lnTo>
                  <a:pt x="809625" y="200025"/>
                </a:lnTo>
                <a:lnTo>
                  <a:pt x="838200" y="180975"/>
                </a:lnTo>
                <a:cubicBezTo>
                  <a:pt x="880304" y="117820"/>
                  <a:pt x="830820" y="187997"/>
                  <a:pt x="885825" y="123825"/>
                </a:cubicBezTo>
                <a:cubicBezTo>
                  <a:pt x="971602" y="23752"/>
                  <a:pt x="863758" y="145194"/>
                  <a:pt x="933450" y="47625"/>
                </a:cubicBezTo>
                <a:lnTo>
                  <a:pt x="981075" y="0"/>
                </a:lnTo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Freihandform 17"/>
          <p:cNvSpPr/>
          <p:nvPr/>
        </p:nvSpPr>
        <p:spPr>
          <a:xfrm>
            <a:off x="3952875" y="2428875"/>
            <a:ext cx="445355" cy="341077"/>
          </a:xfrm>
          <a:custGeom>
            <a:avLst/>
            <a:gdLst>
              <a:gd name="connsiteX0" fmla="*/ 352425 w 445355"/>
              <a:gd name="connsiteY0" fmla="*/ 11803 h 402328"/>
              <a:gd name="connsiteX1" fmla="*/ 142875 w 445355"/>
              <a:gd name="connsiteY1" fmla="*/ 11803 h 402328"/>
              <a:gd name="connsiteX2" fmla="*/ 85725 w 445355"/>
              <a:gd name="connsiteY2" fmla="*/ 68953 h 402328"/>
              <a:gd name="connsiteX3" fmla="*/ 76200 w 445355"/>
              <a:gd name="connsiteY3" fmla="*/ 97528 h 402328"/>
              <a:gd name="connsiteX4" fmla="*/ 38100 w 445355"/>
              <a:gd name="connsiteY4" fmla="*/ 154678 h 402328"/>
              <a:gd name="connsiteX5" fmla="*/ 9525 w 445355"/>
              <a:gd name="connsiteY5" fmla="*/ 211828 h 402328"/>
              <a:gd name="connsiteX6" fmla="*/ 0 w 445355"/>
              <a:gd name="connsiteY6" fmla="*/ 240403 h 402328"/>
              <a:gd name="connsiteX7" fmla="*/ 9525 w 445355"/>
              <a:gd name="connsiteY7" fmla="*/ 326128 h 402328"/>
              <a:gd name="connsiteX8" fmla="*/ 66675 w 445355"/>
              <a:gd name="connsiteY8" fmla="*/ 373753 h 402328"/>
              <a:gd name="connsiteX9" fmla="*/ 123825 w 445355"/>
              <a:gd name="connsiteY9" fmla="*/ 392803 h 402328"/>
              <a:gd name="connsiteX10" fmla="*/ 152400 w 445355"/>
              <a:gd name="connsiteY10" fmla="*/ 402328 h 402328"/>
              <a:gd name="connsiteX11" fmla="*/ 304800 w 445355"/>
              <a:gd name="connsiteY11" fmla="*/ 392803 h 402328"/>
              <a:gd name="connsiteX12" fmla="*/ 333375 w 445355"/>
              <a:gd name="connsiteY12" fmla="*/ 364228 h 402328"/>
              <a:gd name="connsiteX13" fmla="*/ 419100 w 445355"/>
              <a:gd name="connsiteY13" fmla="*/ 297553 h 402328"/>
              <a:gd name="connsiteX14" fmla="*/ 428625 w 445355"/>
              <a:gd name="connsiteY14" fmla="*/ 88003 h 402328"/>
              <a:gd name="connsiteX15" fmla="*/ 371475 w 445355"/>
              <a:gd name="connsiteY15" fmla="*/ 59428 h 402328"/>
              <a:gd name="connsiteX16" fmla="*/ 352425 w 445355"/>
              <a:gd name="connsiteY16" fmla="*/ 11803 h 4023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45355" h="402328">
                <a:moveTo>
                  <a:pt x="352425" y="11803"/>
                </a:moveTo>
                <a:cubicBezTo>
                  <a:pt x="314325" y="3866"/>
                  <a:pt x="202670" y="-10227"/>
                  <a:pt x="142875" y="11803"/>
                </a:cubicBezTo>
                <a:cubicBezTo>
                  <a:pt x="117595" y="21117"/>
                  <a:pt x="85725" y="68953"/>
                  <a:pt x="85725" y="68953"/>
                </a:cubicBezTo>
                <a:cubicBezTo>
                  <a:pt x="82550" y="78478"/>
                  <a:pt x="81076" y="88751"/>
                  <a:pt x="76200" y="97528"/>
                </a:cubicBezTo>
                <a:cubicBezTo>
                  <a:pt x="65081" y="117542"/>
                  <a:pt x="45340" y="132958"/>
                  <a:pt x="38100" y="154678"/>
                </a:cubicBezTo>
                <a:cubicBezTo>
                  <a:pt x="14159" y="226502"/>
                  <a:pt x="46454" y="137970"/>
                  <a:pt x="9525" y="211828"/>
                </a:cubicBezTo>
                <a:cubicBezTo>
                  <a:pt x="5035" y="220808"/>
                  <a:pt x="3175" y="230878"/>
                  <a:pt x="0" y="240403"/>
                </a:cubicBezTo>
                <a:cubicBezTo>
                  <a:pt x="3175" y="268978"/>
                  <a:pt x="433" y="298853"/>
                  <a:pt x="9525" y="326128"/>
                </a:cubicBezTo>
                <a:cubicBezTo>
                  <a:pt x="13426" y="337831"/>
                  <a:pt x="54740" y="368449"/>
                  <a:pt x="66675" y="373753"/>
                </a:cubicBezTo>
                <a:cubicBezTo>
                  <a:pt x="85025" y="381908"/>
                  <a:pt x="104775" y="386453"/>
                  <a:pt x="123825" y="392803"/>
                </a:cubicBezTo>
                <a:lnTo>
                  <a:pt x="152400" y="402328"/>
                </a:lnTo>
                <a:cubicBezTo>
                  <a:pt x="203200" y="399153"/>
                  <a:pt x="254993" y="403289"/>
                  <a:pt x="304800" y="392803"/>
                </a:cubicBezTo>
                <a:cubicBezTo>
                  <a:pt x="317981" y="390028"/>
                  <a:pt x="322742" y="372498"/>
                  <a:pt x="333375" y="364228"/>
                </a:cubicBezTo>
                <a:cubicBezTo>
                  <a:pt x="435912" y="284477"/>
                  <a:pt x="354226" y="362427"/>
                  <a:pt x="419100" y="297553"/>
                </a:cubicBezTo>
                <a:cubicBezTo>
                  <a:pt x="447726" y="211675"/>
                  <a:pt x="455928" y="210867"/>
                  <a:pt x="428625" y="88003"/>
                </a:cubicBezTo>
                <a:cubicBezTo>
                  <a:pt x="425213" y="72648"/>
                  <a:pt x="381514" y="64447"/>
                  <a:pt x="371475" y="59428"/>
                </a:cubicBezTo>
                <a:cubicBezTo>
                  <a:pt x="329853" y="38617"/>
                  <a:pt x="390525" y="19740"/>
                  <a:pt x="352425" y="11803"/>
                </a:cubicBezTo>
                <a:close/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Freihandform 18"/>
          <p:cNvSpPr/>
          <p:nvPr/>
        </p:nvSpPr>
        <p:spPr>
          <a:xfrm>
            <a:off x="4924425" y="485739"/>
            <a:ext cx="1304925" cy="904911"/>
          </a:xfrm>
          <a:custGeom>
            <a:avLst/>
            <a:gdLst>
              <a:gd name="connsiteX0" fmla="*/ 0 w 1304925"/>
              <a:gd name="connsiteY0" fmla="*/ 904911 h 904911"/>
              <a:gd name="connsiteX1" fmla="*/ 47625 w 1304925"/>
              <a:gd name="connsiteY1" fmla="*/ 876336 h 904911"/>
              <a:gd name="connsiteX2" fmla="*/ 104775 w 1304925"/>
              <a:gd name="connsiteY2" fmla="*/ 819186 h 904911"/>
              <a:gd name="connsiteX3" fmla="*/ 133350 w 1304925"/>
              <a:gd name="connsiteY3" fmla="*/ 800136 h 904911"/>
              <a:gd name="connsiteX4" fmla="*/ 180975 w 1304925"/>
              <a:gd name="connsiteY4" fmla="*/ 742986 h 904911"/>
              <a:gd name="connsiteX5" fmla="*/ 247650 w 1304925"/>
              <a:gd name="connsiteY5" fmla="*/ 695361 h 904911"/>
              <a:gd name="connsiteX6" fmla="*/ 276225 w 1304925"/>
              <a:gd name="connsiteY6" fmla="*/ 685836 h 904911"/>
              <a:gd name="connsiteX7" fmla="*/ 333375 w 1304925"/>
              <a:gd name="connsiteY7" fmla="*/ 638211 h 904911"/>
              <a:gd name="connsiteX8" fmla="*/ 361950 w 1304925"/>
              <a:gd name="connsiteY8" fmla="*/ 628686 h 904911"/>
              <a:gd name="connsiteX9" fmla="*/ 400050 w 1304925"/>
              <a:gd name="connsiteY9" fmla="*/ 609636 h 904911"/>
              <a:gd name="connsiteX10" fmla="*/ 457200 w 1304925"/>
              <a:gd name="connsiteY10" fmla="*/ 562011 h 904911"/>
              <a:gd name="connsiteX11" fmla="*/ 485775 w 1304925"/>
              <a:gd name="connsiteY11" fmla="*/ 542961 h 904911"/>
              <a:gd name="connsiteX12" fmla="*/ 514350 w 1304925"/>
              <a:gd name="connsiteY12" fmla="*/ 514386 h 904911"/>
              <a:gd name="connsiteX13" fmla="*/ 542925 w 1304925"/>
              <a:gd name="connsiteY13" fmla="*/ 504861 h 904911"/>
              <a:gd name="connsiteX14" fmla="*/ 600075 w 1304925"/>
              <a:gd name="connsiteY14" fmla="*/ 466761 h 904911"/>
              <a:gd name="connsiteX15" fmla="*/ 628650 w 1304925"/>
              <a:gd name="connsiteY15" fmla="*/ 447711 h 904911"/>
              <a:gd name="connsiteX16" fmla="*/ 657225 w 1304925"/>
              <a:gd name="connsiteY16" fmla="*/ 419136 h 904911"/>
              <a:gd name="connsiteX17" fmla="*/ 685800 w 1304925"/>
              <a:gd name="connsiteY17" fmla="*/ 409611 h 904911"/>
              <a:gd name="connsiteX18" fmla="*/ 742950 w 1304925"/>
              <a:gd name="connsiteY18" fmla="*/ 371511 h 904911"/>
              <a:gd name="connsiteX19" fmla="*/ 762000 w 1304925"/>
              <a:gd name="connsiteY19" fmla="*/ 342936 h 904911"/>
              <a:gd name="connsiteX20" fmla="*/ 819150 w 1304925"/>
              <a:gd name="connsiteY20" fmla="*/ 314361 h 904911"/>
              <a:gd name="connsiteX21" fmla="*/ 838200 w 1304925"/>
              <a:gd name="connsiteY21" fmla="*/ 285786 h 904911"/>
              <a:gd name="connsiteX22" fmla="*/ 933450 w 1304925"/>
              <a:gd name="connsiteY22" fmla="*/ 238161 h 904911"/>
              <a:gd name="connsiteX23" fmla="*/ 990600 w 1304925"/>
              <a:gd name="connsiteY23" fmla="*/ 190536 h 904911"/>
              <a:gd name="connsiteX24" fmla="*/ 1047750 w 1304925"/>
              <a:gd name="connsiteY24" fmla="*/ 152436 h 904911"/>
              <a:gd name="connsiteX25" fmla="*/ 1085850 w 1304925"/>
              <a:gd name="connsiteY25" fmla="*/ 114336 h 904911"/>
              <a:gd name="connsiteX26" fmla="*/ 1114425 w 1304925"/>
              <a:gd name="connsiteY26" fmla="*/ 85761 h 904911"/>
              <a:gd name="connsiteX27" fmla="*/ 1143000 w 1304925"/>
              <a:gd name="connsiteY27" fmla="*/ 76236 h 904911"/>
              <a:gd name="connsiteX28" fmla="*/ 1171575 w 1304925"/>
              <a:gd name="connsiteY28" fmla="*/ 57186 h 904911"/>
              <a:gd name="connsiteX29" fmla="*/ 1200150 w 1304925"/>
              <a:gd name="connsiteY29" fmla="*/ 47661 h 904911"/>
              <a:gd name="connsiteX30" fmla="*/ 1266825 w 1304925"/>
              <a:gd name="connsiteY30" fmla="*/ 19086 h 904911"/>
              <a:gd name="connsiteX31" fmla="*/ 1304925 w 1304925"/>
              <a:gd name="connsiteY31" fmla="*/ 36 h 9049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1304925" h="904911">
                <a:moveTo>
                  <a:pt x="0" y="904911"/>
                </a:moveTo>
                <a:cubicBezTo>
                  <a:pt x="15875" y="895386"/>
                  <a:pt x="33297" y="888059"/>
                  <a:pt x="47625" y="876336"/>
                </a:cubicBezTo>
                <a:cubicBezTo>
                  <a:pt x="68476" y="859276"/>
                  <a:pt x="82359" y="834130"/>
                  <a:pt x="104775" y="819186"/>
                </a:cubicBezTo>
                <a:cubicBezTo>
                  <a:pt x="114300" y="812836"/>
                  <a:pt x="124556" y="807465"/>
                  <a:pt x="133350" y="800136"/>
                </a:cubicBezTo>
                <a:cubicBezTo>
                  <a:pt x="226975" y="722115"/>
                  <a:pt x="106050" y="817911"/>
                  <a:pt x="180975" y="742986"/>
                </a:cubicBezTo>
                <a:cubicBezTo>
                  <a:pt x="185289" y="738672"/>
                  <a:pt x="236833" y="700769"/>
                  <a:pt x="247650" y="695361"/>
                </a:cubicBezTo>
                <a:cubicBezTo>
                  <a:pt x="256630" y="690871"/>
                  <a:pt x="266700" y="689011"/>
                  <a:pt x="276225" y="685836"/>
                </a:cubicBezTo>
                <a:cubicBezTo>
                  <a:pt x="297291" y="664770"/>
                  <a:pt x="306853" y="651472"/>
                  <a:pt x="333375" y="638211"/>
                </a:cubicBezTo>
                <a:cubicBezTo>
                  <a:pt x="342355" y="633721"/>
                  <a:pt x="352722" y="632641"/>
                  <a:pt x="361950" y="628686"/>
                </a:cubicBezTo>
                <a:cubicBezTo>
                  <a:pt x="375001" y="623093"/>
                  <a:pt x="387722" y="616681"/>
                  <a:pt x="400050" y="609636"/>
                </a:cubicBezTo>
                <a:cubicBezTo>
                  <a:pt x="445198" y="583837"/>
                  <a:pt x="414218" y="597829"/>
                  <a:pt x="457200" y="562011"/>
                </a:cubicBezTo>
                <a:cubicBezTo>
                  <a:pt x="465994" y="554682"/>
                  <a:pt x="476981" y="550290"/>
                  <a:pt x="485775" y="542961"/>
                </a:cubicBezTo>
                <a:cubicBezTo>
                  <a:pt x="496123" y="534337"/>
                  <a:pt x="503142" y="521858"/>
                  <a:pt x="514350" y="514386"/>
                </a:cubicBezTo>
                <a:cubicBezTo>
                  <a:pt x="522704" y="508817"/>
                  <a:pt x="534148" y="509737"/>
                  <a:pt x="542925" y="504861"/>
                </a:cubicBezTo>
                <a:cubicBezTo>
                  <a:pt x="562939" y="493742"/>
                  <a:pt x="581025" y="479461"/>
                  <a:pt x="600075" y="466761"/>
                </a:cubicBezTo>
                <a:cubicBezTo>
                  <a:pt x="609600" y="460411"/>
                  <a:pt x="620555" y="455806"/>
                  <a:pt x="628650" y="447711"/>
                </a:cubicBezTo>
                <a:cubicBezTo>
                  <a:pt x="638175" y="438186"/>
                  <a:pt x="646017" y="426608"/>
                  <a:pt x="657225" y="419136"/>
                </a:cubicBezTo>
                <a:cubicBezTo>
                  <a:pt x="665579" y="413567"/>
                  <a:pt x="677023" y="414487"/>
                  <a:pt x="685800" y="409611"/>
                </a:cubicBezTo>
                <a:cubicBezTo>
                  <a:pt x="705814" y="398492"/>
                  <a:pt x="742950" y="371511"/>
                  <a:pt x="742950" y="371511"/>
                </a:cubicBezTo>
                <a:cubicBezTo>
                  <a:pt x="749300" y="361986"/>
                  <a:pt x="753905" y="351031"/>
                  <a:pt x="762000" y="342936"/>
                </a:cubicBezTo>
                <a:cubicBezTo>
                  <a:pt x="780464" y="324472"/>
                  <a:pt x="795909" y="322108"/>
                  <a:pt x="819150" y="314361"/>
                </a:cubicBezTo>
                <a:cubicBezTo>
                  <a:pt x="825500" y="304836"/>
                  <a:pt x="829585" y="293324"/>
                  <a:pt x="838200" y="285786"/>
                </a:cubicBezTo>
                <a:cubicBezTo>
                  <a:pt x="883562" y="246095"/>
                  <a:pt x="886107" y="249997"/>
                  <a:pt x="933450" y="238161"/>
                </a:cubicBezTo>
                <a:cubicBezTo>
                  <a:pt x="1035560" y="170088"/>
                  <a:pt x="880591" y="276099"/>
                  <a:pt x="990600" y="190536"/>
                </a:cubicBezTo>
                <a:cubicBezTo>
                  <a:pt x="1008672" y="176480"/>
                  <a:pt x="1047750" y="152436"/>
                  <a:pt x="1047750" y="152436"/>
                </a:cubicBezTo>
                <a:cubicBezTo>
                  <a:pt x="1065893" y="98007"/>
                  <a:pt x="1042307" y="143365"/>
                  <a:pt x="1085850" y="114336"/>
                </a:cubicBezTo>
                <a:cubicBezTo>
                  <a:pt x="1097058" y="106864"/>
                  <a:pt x="1103217" y="93233"/>
                  <a:pt x="1114425" y="85761"/>
                </a:cubicBezTo>
                <a:cubicBezTo>
                  <a:pt x="1122779" y="80192"/>
                  <a:pt x="1134020" y="80726"/>
                  <a:pt x="1143000" y="76236"/>
                </a:cubicBezTo>
                <a:cubicBezTo>
                  <a:pt x="1153239" y="71116"/>
                  <a:pt x="1161336" y="62306"/>
                  <a:pt x="1171575" y="57186"/>
                </a:cubicBezTo>
                <a:cubicBezTo>
                  <a:pt x="1180555" y="52696"/>
                  <a:pt x="1191170" y="52151"/>
                  <a:pt x="1200150" y="47661"/>
                </a:cubicBezTo>
                <a:cubicBezTo>
                  <a:pt x="1265929" y="14772"/>
                  <a:pt x="1187531" y="38910"/>
                  <a:pt x="1266825" y="19086"/>
                </a:cubicBezTo>
                <a:cubicBezTo>
                  <a:pt x="1298042" y="-1725"/>
                  <a:pt x="1283952" y="36"/>
                  <a:pt x="1304925" y="36"/>
                </a:cubicBezTo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Freihandform 20"/>
          <p:cNvSpPr/>
          <p:nvPr/>
        </p:nvSpPr>
        <p:spPr>
          <a:xfrm>
            <a:off x="5257800" y="952500"/>
            <a:ext cx="981075" cy="695325"/>
          </a:xfrm>
          <a:custGeom>
            <a:avLst/>
            <a:gdLst>
              <a:gd name="connsiteX0" fmla="*/ 0 w 981075"/>
              <a:gd name="connsiteY0" fmla="*/ 695325 h 695325"/>
              <a:gd name="connsiteX1" fmla="*/ 47625 w 981075"/>
              <a:gd name="connsiteY1" fmla="*/ 666750 h 695325"/>
              <a:gd name="connsiteX2" fmla="*/ 57150 w 981075"/>
              <a:gd name="connsiteY2" fmla="*/ 638175 h 695325"/>
              <a:gd name="connsiteX3" fmla="*/ 85725 w 981075"/>
              <a:gd name="connsiteY3" fmla="*/ 619125 h 695325"/>
              <a:gd name="connsiteX4" fmla="*/ 142875 w 981075"/>
              <a:gd name="connsiteY4" fmla="*/ 561975 h 695325"/>
              <a:gd name="connsiteX5" fmla="*/ 171450 w 981075"/>
              <a:gd name="connsiteY5" fmla="*/ 533400 h 695325"/>
              <a:gd name="connsiteX6" fmla="*/ 190500 w 981075"/>
              <a:gd name="connsiteY6" fmla="*/ 504825 h 695325"/>
              <a:gd name="connsiteX7" fmla="*/ 247650 w 981075"/>
              <a:gd name="connsiteY7" fmla="*/ 457200 h 695325"/>
              <a:gd name="connsiteX8" fmla="*/ 276225 w 981075"/>
              <a:gd name="connsiteY8" fmla="*/ 447675 h 695325"/>
              <a:gd name="connsiteX9" fmla="*/ 304800 w 981075"/>
              <a:gd name="connsiteY9" fmla="*/ 419100 h 695325"/>
              <a:gd name="connsiteX10" fmla="*/ 342900 w 981075"/>
              <a:gd name="connsiteY10" fmla="*/ 409575 h 695325"/>
              <a:gd name="connsiteX11" fmla="*/ 400050 w 981075"/>
              <a:gd name="connsiteY11" fmla="*/ 390525 h 695325"/>
              <a:gd name="connsiteX12" fmla="*/ 428625 w 981075"/>
              <a:gd name="connsiteY12" fmla="*/ 381000 h 695325"/>
              <a:gd name="connsiteX13" fmla="*/ 514350 w 981075"/>
              <a:gd name="connsiteY13" fmla="*/ 323850 h 695325"/>
              <a:gd name="connsiteX14" fmla="*/ 542925 w 981075"/>
              <a:gd name="connsiteY14" fmla="*/ 304800 h 695325"/>
              <a:gd name="connsiteX15" fmla="*/ 571500 w 981075"/>
              <a:gd name="connsiteY15" fmla="*/ 295275 h 695325"/>
              <a:gd name="connsiteX16" fmla="*/ 628650 w 981075"/>
              <a:gd name="connsiteY16" fmla="*/ 266700 h 695325"/>
              <a:gd name="connsiteX17" fmla="*/ 685800 w 981075"/>
              <a:gd name="connsiteY17" fmla="*/ 228600 h 695325"/>
              <a:gd name="connsiteX18" fmla="*/ 742950 w 981075"/>
              <a:gd name="connsiteY18" fmla="*/ 190500 h 695325"/>
              <a:gd name="connsiteX19" fmla="*/ 790575 w 981075"/>
              <a:gd name="connsiteY19" fmla="*/ 142875 h 695325"/>
              <a:gd name="connsiteX20" fmla="*/ 819150 w 981075"/>
              <a:gd name="connsiteY20" fmla="*/ 114300 h 695325"/>
              <a:gd name="connsiteX21" fmla="*/ 876300 w 981075"/>
              <a:gd name="connsiteY21" fmla="*/ 85725 h 695325"/>
              <a:gd name="connsiteX22" fmla="*/ 904875 w 981075"/>
              <a:gd name="connsiteY22" fmla="*/ 57150 h 695325"/>
              <a:gd name="connsiteX23" fmla="*/ 933450 w 981075"/>
              <a:gd name="connsiteY23" fmla="*/ 38100 h 695325"/>
              <a:gd name="connsiteX24" fmla="*/ 981075 w 981075"/>
              <a:gd name="connsiteY24" fmla="*/ 0 h 6953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981075" h="695325">
                <a:moveTo>
                  <a:pt x="0" y="695325"/>
                </a:moveTo>
                <a:cubicBezTo>
                  <a:pt x="15875" y="685800"/>
                  <a:pt x="34534" y="679841"/>
                  <a:pt x="47625" y="666750"/>
                </a:cubicBezTo>
                <a:cubicBezTo>
                  <a:pt x="54725" y="659650"/>
                  <a:pt x="50878" y="646015"/>
                  <a:pt x="57150" y="638175"/>
                </a:cubicBezTo>
                <a:cubicBezTo>
                  <a:pt x="64301" y="629236"/>
                  <a:pt x="77169" y="626730"/>
                  <a:pt x="85725" y="619125"/>
                </a:cubicBezTo>
                <a:cubicBezTo>
                  <a:pt x="105861" y="601227"/>
                  <a:pt x="123825" y="581025"/>
                  <a:pt x="142875" y="561975"/>
                </a:cubicBezTo>
                <a:cubicBezTo>
                  <a:pt x="152400" y="552450"/>
                  <a:pt x="163978" y="544608"/>
                  <a:pt x="171450" y="533400"/>
                </a:cubicBezTo>
                <a:cubicBezTo>
                  <a:pt x="177800" y="523875"/>
                  <a:pt x="183171" y="513619"/>
                  <a:pt x="190500" y="504825"/>
                </a:cubicBezTo>
                <a:cubicBezTo>
                  <a:pt x="205547" y="486769"/>
                  <a:pt x="226243" y="467904"/>
                  <a:pt x="247650" y="457200"/>
                </a:cubicBezTo>
                <a:cubicBezTo>
                  <a:pt x="256630" y="452710"/>
                  <a:pt x="266700" y="450850"/>
                  <a:pt x="276225" y="447675"/>
                </a:cubicBezTo>
                <a:cubicBezTo>
                  <a:pt x="285750" y="438150"/>
                  <a:pt x="293104" y="425783"/>
                  <a:pt x="304800" y="419100"/>
                </a:cubicBezTo>
                <a:cubicBezTo>
                  <a:pt x="316166" y="412605"/>
                  <a:pt x="330361" y="413337"/>
                  <a:pt x="342900" y="409575"/>
                </a:cubicBezTo>
                <a:cubicBezTo>
                  <a:pt x="362134" y="403805"/>
                  <a:pt x="381000" y="396875"/>
                  <a:pt x="400050" y="390525"/>
                </a:cubicBezTo>
                <a:cubicBezTo>
                  <a:pt x="409575" y="387350"/>
                  <a:pt x="420271" y="386569"/>
                  <a:pt x="428625" y="381000"/>
                </a:cubicBezTo>
                <a:lnTo>
                  <a:pt x="514350" y="323850"/>
                </a:lnTo>
                <a:cubicBezTo>
                  <a:pt x="523875" y="317500"/>
                  <a:pt x="532065" y="308420"/>
                  <a:pt x="542925" y="304800"/>
                </a:cubicBezTo>
                <a:cubicBezTo>
                  <a:pt x="552450" y="301625"/>
                  <a:pt x="562520" y="299765"/>
                  <a:pt x="571500" y="295275"/>
                </a:cubicBezTo>
                <a:cubicBezTo>
                  <a:pt x="645358" y="258346"/>
                  <a:pt x="556826" y="290641"/>
                  <a:pt x="628650" y="266700"/>
                </a:cubicBezTo>
                <a:cubicBezTo>
                  <a:pt x="692066" y="203284"/>
                  <a:pt x="623769" y="263062"/>
                  <a:pt x="685800" y="228600"/>
                </a:cubicBezTo>
                <a:cubicBezTo>
                  <a:pt x="705814" y="217481"/>
                  <a:pt x="742950" y="190500"/>
                  <a:pt x="742950" y="190500"/>
                </a:cubicBezTo>
                <a:cubicBezTo>
                  <a:pt x="777875" y="138113"/>
                  <a:pt x="742950" y="182562"/>
                  <a:pt x="790575" y="142875"/>
                </a:cubicBezTo>
                <a:cubicBezTo>
                  <a:pt x="800923" y="134251"/>
                  <a:pt x="807942" y="121772"/>
                  <a:pt x="819150" y="114300"/>
                </a:cubicBezTo>
                <a:cubicBezTo>
                  <a:pt x="905067" y="57022"/>
                  <a:pt x="786374" y="160663"/>
                  <a:pt x="876300" y="85725"/>
                </a:cubicBezTo>
                <a:cubicBezTo>
                  <a:pt x="886648" y="77101"/>
                  <a:pt x="894527" y="65774"/>
                  <a:pt x="904875" y="57150"/>
                </a:cubicBezTo>
                <a:cubicBezTo>
                  <a:pt x="913669" y="49821"/>
                  <a:pt x="924656" y="45429"/>
                  <a:pt x="933450" y="38100"/>
                </a:cubicBezTo>
                <a:cubicBezTo>
                  <a:pt x="983843" y="-3894"/>
                  <a:pt x="941124" y="19976"/>
                  <a:pt x="981075" y="0"/>
                </a:cubicBezTo>
              </a:path>
            </a:pathLst>
          </a:custGeom>
          <a:noFill/>
          <a:ln w="190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2" name="Textfeld 43"/>
          <p:cNvSpPr txBox="1">
            <a:spLocks noChangeArrowheads="1"/>
          </p:cNvSpPr>
          <p:nvPr/>
        </p:nvSpPr>
        <p:spPr bwMode="auto">
          <a:xfrm>
            <a:off x="3098917" y="329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43"/>
          <p:cNvSpPr txBox="1">
            <a:spLocks noChangeArrowheads="1"/>
          </p:cNvSpPr>
          <p:nvPr/>
        </p:nvSpPr>
        <p:spPr bwMode="auto">
          <a:xfrm>
            <a:off x="-6233" y="3291"/>
            <a:ext cx="3952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271803" y="3036611"/>
            <a:ext cx="575780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ure 6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-intrinsic autofluorescence allows identification of large and small airways/blood vessel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00 µm lung sections of agarose filled lungs were prepared. Large airways and small airways/blood vessels were identified by tissue autofluorescence. Staining with anti-TCRβ allowed identification of immune cells around airways. Discrimination between larg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mall airways/blood vessel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carried out at a threshold diameter of 100 µm. Stained slices were evaluated with laser scanning confocal microscopy. Dashed lines indicate borders of airways/blood vessels. Data are representative of two independent experiments.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198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85</Words>
  <Application>Microsoft Office PowerPoint</Application>
  <PresentationFormat>Benutzerdefiniert</PresentationFormat>
  <Paragraphs>110</Paragraphs>
  <Slides>6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5" baseType="lpstr">
      <vt:lpstr>Arial</vt:lpstr>
      <vt:lpstr>Calibri</vt:lpstr>
      <vt:lpstr>Calibri Light</vt:lpstr>
      <vt:lpstr>Cambria Math</vt:lpstr>
      <vt:lpstr>MS Mincho</vt:lpstr>
      <vt:lpstr>Times</vt:lpstr>
      <vt:lpstr>Times New Roman</vt:lpstr>
      <vt:lpstr>Office Theme</vt:lpstr>
      <vt:lpstr>Prism 5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nken</dc:creator>
  <cp:lastModifiedBy>Inken Schmudde</cp:lastModifiedBy>
  <cp:revision>255</cp:revision>
  <cp:lastPrinted>2017-11-07T10:58:11Z</cp:lastPrinted>
  <dcterms:created xsi:type="dcterms:W3CDTF">2016-12-16T12:59:21Z</dcterms:created>
  <dcterms:modified xsi:type="dcterms:W3CDTF">2022-07-27T22:06:05Z</dcterms:modified>
</cp:coreProperties>
</file>